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2"/>
  </p:notesMasterIdLst>
  <p:sldIdLst>
    <p:sldId id="256" r:id="rId2"/>
    <p:sldId id="267" r:id="rId3"/>
    <p:sldId id="291" r:id="rId4"/>
    <p:sldId id="269" r:id="rId5"/>
    <p:sldId id="257" r:id="rId6"/>
    <p:sldId id="258" r:id="rId7"/>
    <p:sldId id="287" r:id="rId8"/>
    <p:sldId id="259" r:id="rId9"/>
    <p:sldId id="270" r:id="rId10"/>
    <p:sldId id="290" r:id="rId11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E9ACAC"/>
    <a:srgbClr val="7FB2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006" autoAdjust="0"/>
    <p:restoredTop sz="94660"/>
  </p:normalViewPr>
  <p:slideViewPr>
    <p:cSldViewPr snapToGrid="0">
      <p:cViewPr varScale="1">
        <p:scale>
          <a:sx n="76" d="100"/>
          <a:sy n="76" d="100"/>
        </p:scale>
        <p:origin x="341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8EDF98B9-5996-4D98-950B-1F55C927E14B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CEA4377A-3BA8-457D-8874-AF02159FB5D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55467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9081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00343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3205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47446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9184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4257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2606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3873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50237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0339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13852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2025B2-7061-480B-B458-262FD7ACEBE3}" type="datetimeFigureOut">
              <a:rPr lang="en-IN" smtClean="0"/>
              <a:t>09-07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803C5-DA2A-4BF5-A8DB-021C9104476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09776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emf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12" Type="http://schemas.openxmlformats.org/officeDocument/2006/relationships/image" Target="../media/image47.emf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11" Type="http://schemas.openxmlformats.org/officeDocument/2006/relationships/image" Target="../media/image46.emf"/><Relationship Id="rId5" Type="http://schemas.openxmlformats.org/officeDocument/2006/relationships/image" Target="../media/image40.png"/><Relationship Id="rId10" Type="http://schemas.openxmlformats.org/officeDocument/2006/relationships/image" Target="../media/image45.emf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E34C07E2-DDA7-547F-8A2F-FD0FD766EF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52500" y="3757172"/>
            <a:ext cx="5143500" cy="2391656"/>
          </a:xfrm>
        </p:spPr>
        <p:txBody>
          <a:bodyPr/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  <a:endParaRPr lang="en-IN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9441913E-819E-EB6D-60CC-2E71C6EE54B3}"/>
              </a:ext>
            </a:extLst>
          </p:cNvPr>
          <p:cNvSpPr txBox="1">
            <a:spLocks/>
          </p:cNvSpPr>
          <p:nvPr/>
        </p:nvSpPr>
        <p:spPr>
          <a:xfrm>
            <a:off x="609600" y="2311400"/>
            <a:ext cx="5829300" cy="3448756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dirty="0">
                <a:latin typeface="Times New Roman" panose="02020603050405020304" pitchFamily="18" charset="0"/>
                <a:ea typeface="SimSun" panose="02010600030101010101" pitchFamily="2" charset="-122"/>
              </a:rPr>
              <a:t>Ribonucleoprotein (RNP) condensates modulate survival in response to Mars-like stress conditions</a:t>
            </a:r>
            <a:br>
              <a:rPr lang="en-IN" sz="1800" dirty="0">
                <a:latin typeface="Times New Roman" panose="02020603050405020304" pitchFamily="18" charset="0"/>
                <a:ea typeface="SimSun" panose="02010600030101010101" pitchFamily="2" charset="-122"/>
              </a:rPr>
            </a:br>
            <a:br>
              <a:rPr lang="en-IN" sz="1800" b="1" dirty="0">
                <a:latin typeface="Times New Roman" panose="02020603050405020304" pitchFamily="18" charset="0"/>
                <a:ea typeface="MS Mincho" panose="02020609040205080304" pitchFamily="49" charset="-128"/>
              </a:rPr>
            </a:br>
            <a:endParaRPr lang="en-IN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E22362C-3F95-025E-8977-C0F7029D1DA6}"/>
              </a:ext>
            </a:extLst>
          </p:cNvPr>
          <p:cNvSpPr txBox="1"/>
          <p:nvPr/>
        </p:nvSpPr>
        <p:spPr>
          <a:xfrm>
            <a:off x="1270000" y="5181600"/>
            <a:ext cx="5740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IN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iya Dhage, Arijit Roy, </a:t>
            </a:r>
            <a:r>
              <a:rPr lang="en-IN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halamurugan</a:t>
            </a:r>
            <a:r>
              <a:rPr lang="en-IN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ivaraman and </a:t>
            </a:r>
            <a:r>
              <a:rPr lang="en-IN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urusharth</a:t>
            </a:r>
            <a:r>
              <a:rPr lang="en-IN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 </a:t>
            </a:r>
            <a:r>
              <a:rPr lang="en-IN" sz="1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Rajyaguru</a:t>
            </a:r>
            <a:endParaRPr lang="en-IN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473646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0D1F7BA4-A8F3-F573-57CA-83C90F9464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1980" y="6175486"/>
            <a:ext cx="1712822" cy="192242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14767DF5-3897-0354-CA10-3A0D61E6581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542095" y="6114881"/>
            <a:ext cx="1644776" cy="189398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E58BF3A-9313-BB5E-D844-B69C94076C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11349" y="4159951"/>
            <a:ext cx="1698283" cy="180753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60CDA6E-412A-6A13-99E4-6928A76BB7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1096" y="2045285"/>
            <a:ext cx="1237890" cy="188737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F50DC45-BE3E-EBB8-73DF-5BD0AF2982B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39420" y="2086068"/>
            <a:ext cx="1195636" cy="1779332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56FD622-FDE2-0CE7-EB73-ECB2B243F0E7}"/>
              </a:ext>
            </a:extLst>
          </p:cNvPr>
          <p:cNvSpPr txBox="1"/>
          <p:nvPr/>
        </p:nvSpPr>
        <p:spPr>
          <a:xfrm>
            <a:off x="-61026" y="-32262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51DE869-3A54-6970-9773-F21CA48E08B7}"/>
              </a:ext>
            </a:extLst>
          </p:cNvPr>
          <p:cNvSpPr txBox="1"/>
          <p:nvPr/>
        </p:nvSpPr>
        <p:spPr>
          <a:xfrm>
            <a:off x="114035" y="1996550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AA94BE7-9E70-8352-75D4-5D2B8456AFDF}"/>
              </a:ext>
            </a:extLst>
          </p:cNvPr>
          <p:cNvSpPr txBox="1"/>
          <p:nvPr/>
        </p:nvSpPr>
        <p:spPr>
          <a:xfrm>
            <a:off x="1821546" y="1977604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4DFECE0-88DA-48E6-F2AB-8426E5F37102}"/>
              </a:ext>
            </a:extLst>
          </p:cNvPr>
          <p:cNvSpPr txBox="1"/>
          <p:nvPr/>
        </p:nvSpPr>
        <p:spPr>
          <a:xfrm>
            <a:off x="2051202" y="4173228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5AC5736-5A11-BB10-536D-BCF2089B69B6}"/>
              </a:ext>
            </a:extLst>
          </p:cNvPr>
          <p:cNvSpPr txBox="1"/>
          <p:nvPr/>
        </p:nvSpPr>
        <p:spPr>
          <a:xfrm>
            <a:off x="3452930" y="1949953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BF3EDCEA-35A4-D732-FF34-8405CCB399A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392" b="1392"/>
          <a:stretch/>
        </p:blipFill>
        <p:spPr>
          <a:xfrm>
            <a:off x="2529319" y="100601"/>
            <a:ext cx="4327647" cy="1804958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95BE5234-612B-1AF4-0B16-B37790305325}"/>
              </a:ext>
            </a:extLst>
          </p:cNvPr>
          <p:cNvSpPr txBox="1"/>
          <p:nvPr/>
        </p:nvSpPr>
        <p:spPr>
          <a:xfrm>
            <a:off x="86236" y="4159951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2F3D0A5-B171-6F47-C886-E34BF4F91E35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t="25539" b="13769"/>
          <a:stretch/>
        </p:blipFill>
        <p:spPr>
          <a:xfrm>
            <a:off x="4497370" y="4141749"/>
            <a:ext cx="1754600" cy="192197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18979F1-5E42-131C-6314-98C09E004FCE}"/>
              </a:ext>
            </a:extLst>
          </p:cNvPr>
          <p:cNvSpPr txBox="1"/>
          <p:nvPr/>
        </p:nvSpPr>
        <p:spPr>
          <a:xfrm>
            <a:off x="845897" y="3771559"/>
            <a:ext cx="10871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NaClO4 Treated</a:t>
            </a:r>
            <a:endParaRPr lang="en-IN" sz="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1D8051FB-E509-5F4E-F46C-54A937B7D0E7}"/>
              </a:ext>
            </a:extLst>
          </p:cNvPr>
          <p:cNvGrpSpPr/>
          <p:nvPr/>
        </p:nvGrpSpPr>
        <p:grpSpPr>
          <a:xfrm>
            <a:off x="410071" y="4116181"/>
            <a:ext cx="1813540" cy="1998035"/>
            <a:chOff x="3059659" y="1930909"/>
            <a:chExt cx="1813540" cy="1998035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EAF0D6DA-564C-57FD-0C0A-B577A042F38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059659" y="1930909"/>
              <a:ext cx="1700745" cy="1861129"/>
            </a:xfrm>
            <a:prstGeom prst="rect">
              <a:avLst/>
            </a:prstGeom>
          </p:spPr>
        </p:pic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7BFEBDD4-89E9-DE59-751F-AECB63B8328C}"/>
                </a:ext>
              </a:extLst>
            </p:cNvPr>
            <p:cNvGrpSpPr/>
            <p:nvPr/>
          </p:nvGrpSpPr>
          <p:grpSpPr>
            <a:xfrm>
              <a:off x="3392574" y="3699568"/>
              <a:ext cx="1480625" cy="229376"/>
              <a:chOff x="1021914" y="4831346"/>
              <a:chExt cx="1480625" cy="229376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0B9DB67-049C-C861-7BCB-66BA2298C6F2}"/>
                  </a:ext>
                </a:extLst>
              </p:cNvPr>
              <p:cNvSpPr txBox="1"/>
              <p:nvPr/>
            </p:nvSpPr>
            <p:spPr>
              <a:xfrm>
                <a:off x="1021914" y="4845278"/>
                <a:ext cx="14806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3∆lsm4∆C </a:t>
                </a:r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ClO4 Treated</a:t>
                </a:r>
                <a:endParaRPr lang="en-IN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4" name="Straight Connector 23">
                <a:extLst>
                  <a:ext uri="{FF2B5EF4-FFF2-40B4-BE49-F238E27FC236}">
                    <a16:creationId xmlns:a16="http://schemas.microsoft.com/office/drawing/2014/main" id="{A911C04B-DACD-E35C-8996-C2C4C4A9A6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4290" y="4831346"/>
                <a:ext cx="1227104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8A70C560-F2F5-E9C7-C503-746D6F2D77F7}"/>
              </a:ext>
            </a:extLst>
          </p:cNvPr>
          <p:cNvGrpSpPr/>
          <p:nvPr/>
        </p:nvGrpSpPr>
        <p:grpSpPr>
          <a:xfrm>
            <a:off x="5220784" y="5872710"/>
            <a:ext cx="1147567" cy="215295"/>
            <a:chOff x="6144521" y="1742747"/>
            <a:chExt cx="1147567" cy="215295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BF3D4C8-AD45-0F92-1FB1-FBA9702D55C1}"/>
                </a:ext>
              </a:extLst>
            </p:cNvPr>
            <p:cNvSpPr txBox="1"/>
            <p:nvPr/>
          </p:nvSpPr>
          <p:spPr>
            <a:xfrm>
              <a:off x="6204925" y="1757987"/>
              <a:ext cx="10871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NaClO4 Treated</a:t>
              </a:r>
              <a:endParaRPr lang="en-IN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E282DF01-C2C5-81E3-357F-CA8E7EE0B9B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44521" y="1742747"/>
              <a:ext cx="954092" cy="538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77D43923-A41C-4593-661B-1E04BC543419}"/>
              </a:ext>
            </a:extLst>
          </p:cNvPr>
          <p:cNvGrpSpPr/>
          <p:nvPr/>
        </p:nvGrpSpPr>
        <p:grpSpPr>
          <a:xfrm>
            <a:off x="2944168" y="5909771"/>
            <a:ext cx="1480625" cy="229376"/>
            <a:chOff x="1021914" y="4831346"/>
            <a:chExt cx="1480625" cy="229376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A9D8093-7BF1-9019-98CD-E3AC56FF4189}"/>
                </a:ext>
              </a:extLst>
            </p:cNvPr>
            <p:cNvSpPr txBox="1"/>
            <p:nvPr/>
          </p:nvSpPr>
          <p:spPr>
            <a:xfrm>
              <a:off x="1021914" y="4845278"/>
              <a:ext cx="1480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3∆lsm4∆C </a:t>
              </a:r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aClO4 Treated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E86B6DFE-29AC-B7A5-A802-3829B7339F41}"/>
                </a:ext>
              </a:extLst>
            </p:cNvPr>
            <p:cNvCxnSpPr>
              <a:cxnSpLocks/>
            </p:cNvCxnSpPr>
            <p:nvPr/>
          </p:nvCxnSpPr>
          <p:spPr>
            <a:xfrm>
              <a:off x="1124290" y="4831346"/>
              <a:ext cx="1227104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F031152B-2C51-7A03-D93A-19F1A69072FA}"/>
              </a:ext>
            </a:extLst>
          </p:cNvPr>
          <p:cNvSpPr txBox="1"/>
          <p:nvPr/>
        </p:nvSpPr>
        <p:spPr>
          <a:xfrm>
            <a:off x="234390" y="6200838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FDD024C-8D9A-5723-4937-1484BC0CCD3E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3276" t="11747" b="9706"/>
          <a:stretch/>
        </p:blipFill>
        <p:spPr>
          <a:xfrm>
            <a:off x="558147" y="6161014"/>
            <a:ext cx="1746367" cy="1853661"/>
          </a:xfrm>
          <a:prstGeom prst="rect">
            <a:avLst/>
          </a:prstGeom>
        </p:spPr>
      </p:pic>
      <p:grpSp>
        <p:nvGrpSpPr>
          <p:cNvPr id="49" name="Group 48">
            <a:extLst>
              <a:ext uri="{FF2B5EF4-FFF2-40B4-BE49-F238E27FC236}">
                <a16:creationId xmlns:a16="http://schemas.microsoft.com/office/drawing/2014/main" id="{20EEF91A-8370-3130-E445-A2D11D0E2D3F}"/>
              </a:ext>
            </a:extLst>
          </p:cNvPr>
          <p:cNvGrpSpPr/>
          <p:nvPr/>
        </p:nvGrpSpPr>
        <p:grpSpPr>
          <a:xfrm>
            <a:off x="1046323" y="7878418"/>
            <a:ext cx="1480625" cy="229376"/>
            <a:chOff x="983814" y="4831346"/>
            <a:chExt cx="1480625" cy="229376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74FB5859-EB93-4405-2DA1-1EA3144DC85D}"/>
                </a:ext>
              </a:extLst>
            </p:cNvPr>
            <p:cNvSpPr txBox="1"/>
            <p:nvPr/>
          </p:nvSpPr>
          <p:spPr>
            <a:xfrm>
              <a:off x="983814" y="4845278"/>
              <a:ext cx="14806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3∆lsm4∆C </a:t>
              </a:r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aClO4 Treated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2F4A3F7C-23BA-6D21-F1DE-5CB9F2695CA5}"/>
                </a:ext>
              </a:extLst>
            </p:cNvPr>
            <p:cNvCxnSpPr>
              <a:cxnSpLocks/>
            </p:cNvCxnSpPr>
            <p:nvPr/>
          </p:nvCxnSpPr>
          <p:spPr>
            <a:xfrm>
              <a:off x="1124290" y="4831346"/>
              <a:ext cx="1142507" cy="1393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B5DEF177-E195-44F2-E0EA-E9A57869F11A}"/>
              </a:ext>
            </a:extLst>
          </p:cNvPr>
          <p:cNvGrpSpPr/>
          <p:nvPr/>
        </p:nvGrpSpPr>
        <p:grpSpPr>
          <a:xfrm>
            <a:off x="2465718" y="3752608"/>
            <a:ext cx="972271" cy="184666"/>
            <a:chOff x="6315562" y="1742099"/>
            <a:chExt cx="954092" cy="137157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BA48F84-7181-3F67-B42E-79F969FFE84A}"/>
                </a:ext>
              </a:extLst>
            </p:cNvPr>
            <p:cNvSpPr txBox="1"/>
            <p:nvPr/>
          </p:nvSpPr>
          <p:spPr>
            <a:xfrm>
              <a:off x="6315562" y="1742099"/>
              <a:ext cx="954092" cy="137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NaClO4 Treated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1FCFA64C-E4B8-0B53-727F-289AC87A7900}"/>
                </a:ext>
              </a:extLst>
            </p:cNvPr>
            <p:cNvCxnSpPr>
              <a:cxnSpLocks/>
            </p:cNvCxnSpPr>
            <p:nvPr/>
          </p:nvCxnSpPr>
          <p:spPr>
            <a:xfrm>
              <a:off x="6373276" y="1742747"/>
              <a:ext cx="66551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43620BAB-90F1-DBB1-87C4-14BDA7218A19}"/>
              </a:ext>
            </a:extLst>
          </p:cNvPr>
          <p:cNvGrpSpPr/>
          <p:nvPr/>
        </p:nvGrpSpPr>
        <p:grpSpPr>
          <a:xfrm>
            <a:off x="2781815" y="7964289"/>
            <a:ext cx="1314450" cy="215444"/>
            <a:chOff x="1566904" y="7475488"/>
            <a:chExt cx="1314450" cy="215444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40C20C7-3F90-882D-4755-C57C755A5852}"/>
                </a:ext>
              </a:extLst>
            </p:cNvPr>
            <p:cNvSpPr txBox="1"/>
            <p:nvPr/>
          </p:nvSpPr>
          <p:spPr>
            <a:xfrm>
              <a:off x="1813882" y="7475488"/>
              <a:ext cx="9113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shocked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AF5FEA28-6D8A-7869-E79C-1DC9A303967F}"/>
                </a:ext>
              </a:extLst>
            </p:cNvPr>
            <p:cNvCxnSpPr>
              <a:cxnSpLocks/>
            </p:cNvCxnSpPr>
            <p:nvPr/>
          </p:nvCxnSpPr>
          <p:spPr>
            <a:xfrm>
              <a:off x="1566904" y="7481130"/>
              <a:ext cx="131445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12CC487A-C186-FD4A-607F-ED7878F3D9B2}"/>
              </a:ext>
            </a:extLst>
          </p:cNvPr>
          <p:cNvGrpSpPr/>
          <p:nvPr/>
        </p:nvGrpSpPr>
        <p:grpSpPr>
          <a:xfrm>
            <a:off x="5043242" y="8027574"/>
            <a:ext cx="1314450" cy="215444"/>
            <a:chOff x="1566904" y="7475488"/>
            <a:chExt cx="1314450" cy="215444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03A77E7-8DFB-002C-8572-60D0285EAE34}"/>
                </a:ext>
              </a:extLst>
            </p:cNvPr>
            <p:cNvSpPr txBox="1"/>
            <p:nvPr/>
          </p:nvSpPr>
          <p:spPr>
            <a:xfrm>
              <a:off x="1813882" y="7475488"/>
              <a:ext cx="9113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shocked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7515A570-5D61-3ECD-0AE9-9B8539C1ED58}"/>
                </a:ext>
              </a:extLst>
            </p:cNvPr>
            <p:cNvCxnSpPr>
              <a:cxnSpLocks/>
            </p:cNvCxnSpPr>
            <p:nvPr/>
          </p:nvCxnSpPr>
          <p:spPr>
            <a:xfrm>
              <a:off x="1566904" y="7481130"/>
              <a:ext cx="131445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352CE3B7-8419-906E-F955-C1C3DD5C5A40}"/>
              </a:ext>
            </a:extLst>
          </p:cNvPr>
          <p:cNvSpPr txBox="1"/>
          <p:nvPr/>
        </p:nvSpPr>
        <p:spPr>
          <a:xfrm>
            <a:off x="4148404" y="4216974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 Box 2">
            <a:extLst>
              <a:ext uri="{FF2B5EF4-FFF2-40B4-BE49-F238E27FC236}">
                <a16:creationId xmlns:a16="http://schemas.microsoft.com/office/drawing/2014/main" id="{AE5F70BA-6400-E1F2-CAFB-DF1A369179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88" y="8189478"/>
            <a:ext cx="6714321" cy="165254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000" b="1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7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: </a:t>
            </a:r>
            <a:r>
              <a:rPr lang="en-US" sz="1000" b="1" dirty="0">
                <a:latin typeface="Times New Roman" panose="02020603050405020304" pitchFamily="18" charset="0"/>
                <a:ea typeface="SimSun" panose="02010600030101010101" pitchFamily="2" charset="-122"/>
              </a:rPr>
              <a:t>mRNA abundance of 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differentially expressed genes by RNA-seq</a:t>
            </a:r>
            <a:r>
              <a:rPr lang="en-US" sz="1000" b="1" dirty="0">
                <a:latin typeface="Times New Roman" panose="02020603050405020304" pitchFamily="18" charset="0"/>
                <a:ea typeface="SimSun" panose="02010600030101010101" pitchFamily="2" charset="-122"/>
              </a:rPr>
              <a:t> analysis.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[A] Changes in abundance of transcripts of different controls genes by RT-qPCR analysis, left-considering ACT1 as internal control, right-considering PGK1 as internal control (n=3).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n the above experiments, error bars represent Standard Error of the Mean.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[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B-D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] Relative mRNA levels by RNA-seq in wildtype untreated vs sodium perchlorate treated for [B-C and G] upregulated transcripts, [D] downregulated transcripts. [E] Relative mRNA levels for transcripts neutrally expressed in wildtype upon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NaClO4 treatment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but downregulated in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∆lsm4∆C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ium perchlorate treated condition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by RNA-seq. [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F-G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] Relative mRNA levels for transcripts upregulated in wild-type upon NaClO4 treatment but downregulated in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∆lsm4∆C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ium perchlorate treated condition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by RNA-seq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 involved in [F] protein folding and cell wall organization, [G] ascospore formation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. [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I-J]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Relative mRNA levels by RNA-seq in wildtype unshocked vs shocked condition for [J] upregulated transcripts, [K] downregulated transcripts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.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he above experiments, bars represent mean from duplicates. 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EA8EE211-B743-91A9-5E8B-DB47A04A2746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3825" t="11192" r="3104" b="9074"/>
          <a:stretch/>
        </p:blipFill>
        <p:spPr>
          <a:xfrm>
            <a:off x="3780247" y="1946739"/>
            <a:ext cx="1735647" cy="1985925"/>
          </a:xfrm>
          <a:prstGeom prst="rect">
            <a:avLst/>
          </a:prstGeom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794AF015-EAB6-C285-F80B-E0787B48FEB5}"/>
              </a:ext>
            </a:extLst>
          </p:cNvPr>
          <p:cNvSpPr txBox="1"/>
          <p:nvPr/>
        </p:nvSpPr>
        <p:spPr>
          <a:xfrm>
            <a:off x="2157275" y="6080785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4A31A0E-34D7-635A-C2B5-3473F68332EB}"/>
              </a:ext>
            </a:extLst>
          </p:cNvPr>
          <p:cNvSpPr txBox="1"/>
          <p:nvPr/>
        </p:nvSpPr>
        <p:spPr>
          <a:xfrm>
            <a:off x="4186871" y="6152696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C131524-330D-3886-0A1C-8CB121F9FE98}"/>
              </a:ext>
            </a:extLst>
          </p:cNvPr>
          <p:cNvGrpSpPr/>
          <p:nvPr/>
        </p:nvGrpSpPr>
        <p:grpSpPr>
          <a:xfrm>
            <a:off x="4311576" y="3837915"/>
            <a:ext cx="1154815" cy="185423"/>
            <a:chOff x="6373276" y="1742099"/>
            <a:chExt cx="1133223" cy="13771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297A388-D47E-047B-3E97-E6879E842A80}"/>
                </a:ext>
              </a:extLst>
            </p:cNvPr>
            <p:cNvSpPr txBox="1"/>
            <p:nvPr/>
          </p:nvSpPr>
          <p:spPr>
            <a:xfrm>
              <a:off x="6552407" y="1742661"/>
              <a:ext cx="954092" cy="1371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NaClO4 Treated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FDE1A265-D134-60CD-DE41-A0860AF4AC8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73276" y="1742099"/>
              <a:ext cx="1043216" cy="64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98F6FA7D-C818-9C57-DD4F-1E692D7C2D78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t="26297" r="39510"/>
          <a:stretch/>
        </p:blipFill>
        <p:spPr>
          <a:xfrm>
            <a:off x="1740" y="76482"/>
            <a:ext cx="2748809" cy="18665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8568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 Box 2">
            <a:extLst>
              <a:ext uri="{FF2B5EF4-FFF2-40B4-BE49-F238E27FC236}">
                <a16:creationId xmlns:a16="http://schemas.microsoft.com/office/drawing/2014/main" id="{B9033B39-A1FC-F3F1-7FEC-0CE82CB58E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480" y="2903911"/>
            <a:ext cx="6753225" cy="99164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000" b="1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1: 5.6 Mach intensity shock induces assembly condensate resident protein Scd6 granules in wildtype (BY4741) yeast strain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.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[A] Microscopy analysis for wildtype (BY4741) yeast strain under 5.6 Mach intensity shock conditions. Arrows represent Scd6-GFP granules. Scale Bar, 2 µm. [B]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Graph depicting the number of Scd6-GFP granules per cell in wild-type in shocked (5.6M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)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and no shock conditions. 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he above experiments, error bars represent Standard Error of the Mean. </a:t>
            </a:r>
            <a:r>
              <a:rPr lang="en-IN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significance of the data was calculated by paired </a:t>
            </a:r>
            <a:r>
              <a:rPr lang="en-IN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</a:t>
            </a:r>
            <a:r>
              <a:rPr lang="en-IN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test and </a:t>
            </a:r>
            <a:r>
              <a:rPr lang="en-IN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-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values are summarized as: </a:t>
            </a:r>
            <a:r>
              <a:rPr lang="en-US" sz="1000" kern="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**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 &lt;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0.005.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EF53C60-D7CB-9391-716F-060C782B5D97}"/>
              </a:ext>
            </a:extLst>
          </p:cNvPr>
          <p:cNvSpPr txBox="1"/>
          <p:nvPr/>
        </p:nvSpPr>
        <p:spPr>
          <a:xfrm>
            <a:off x="55113" y="296460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3B7B0CA7-6957-393C-7BBF-FD137C8010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06241" y="545305"/>
            <a:ext cx="1520369" cy="2058196"/>
          </a:xfrm>
          <a:prstGeom prst="rect">
            <a:avLst/>
          </a:prstGeom>
        </p:spPr>
      </p:pic>
      <p:grpSp>
        <p:nvGrpSpPr>
          <p:cNvPr id="52" name="Group 51">
            <a:extLst>
              <a:ext uri="{FF2B5EF4-FFF2-40B4-BE49-F238E27FC236}">
                <a16:creationId xmlns:a16="http://schemas.microsoft.com/office/drawing/2014/main" id="{5E6DFB3C-A96A-7D41-74AF-7D7F5E5D4E82}"/>
              </a:ext>
            </a:extLst>
          </p:cNvPr>
          <p:cNvGrpSpPr/>
          <p:nvPr/>
        </p:nvGrpSpPr>
        <p:grpSpPr>
          <a:xfrm>
            <a:off x="434819" y="641984"/>
            <a:ext cx="4166824" cy="1452246"/>
            <a:chOff x="1063469" y="299085"/>
            <a:chExt cx="4166824" cy="1452246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437BC4F-A608-4796-49EA-914AAA57C678}"/>
                </a:ext>
              </a:extLst>
            </p:cNvPr>
            <p:cNvSpPr txBox="1"/>
            <p:nvPr/>
          </p:nvSpPr>
          <p:spPr>
            <a:xfrm>
              <a:off x="1162980" y="583627"/>
              <a:ext cx="733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C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86FF067-3807-9FA5-C659-9AD78C6D1A28}"/>
                </a:ext>
              </a:extLst>
            </p:cNvPr>
            <p:cNvSpPr txBox="1"/>
            <p:nvPr/>
          </p:nvSpPr>
          <p:spPr>
            <a:xfrm>
              <a:off x="1947047" y="578466"/>
              <a:ext cx="12382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d6-GFP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7551567-51BB-B615-146B-EFC287D1257C}"/>
                </a:ext>
              </a:extLst>
            </p:cNvPr>
            <p:cNvSpPr txBox="1"/>
            <p:nvPr/>
          </p:nvSpPr>
          <p:spPr>
            <a:xfrm>
              <a:off x="1484585" y="304700"/>
              <a:ext cx="16535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ld-type (No shock)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1D092AF8-A087-289E-FF7E-24B0D9D4BAF0}"/>
                </a:ext>
              </a:extLst>
            </p:cNvPr>
            <p:cNvCxnSpPr>
              <a:cxnSpLocks/>
            </p:cNvCxnSpPr>
            <p:nvPr/>
          </p:nvCxnSpPr>
          <p:spPr>
            <a:xfrm>
              <a:off x="1063469" y="550019"/>
              <a:ext cx="1959132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E366B53-0C69-6368-D32F-84EAAC78EF33}"/>
                </a:ext>
              </a:extLst>
            </p:cNvPr>
            <p:cNvSpPr txBox="1"/>
            <p:nvPr/>
          </p:nvSpPr>
          <p:spPr>
            <a:xfrm>
              <a:off x="3429000" y="299085"/>
              <a:ext cx="17649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ld-type( 5.6 M Shock)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1637CA05-CFD5-1494-99D9-4CE5E943A8B5}"/>
                </a:ext>
              </a:extLst>
            </p:cNvPr>
            <p:cNvCxnSpPr>
              <a:cxnSpLocks/>
            </p:cNvCxnSpPr>
            <p:nvPr/>
          </p:nvCxnSpPr>
          <p:spPr>
            <a:xfrm>
              <a:off x="3138125" y="549471"/>
              <a:ext cx="194123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3F812B5-9DC0-8151-47F5-72F352EDC3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138125" y="851331"/>
              <a:ext cx="912857" cy="9000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6124476F-9450-A5C5-AF3F-9AB98E63176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66505" y="851331"/>
              <a:ext cx="912857" cy="9000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8F633DF0-EFA1-48E0-D54C-FE89F0B1784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109744" y="851331"/>
              <a:ext cx="912857" cy="90000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C3C1742E-DAC5-73C2-C8CE-D53D98A4B0C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81363" y="851331"/>
              <a:ext cx="912857" cy="900000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A0E2EC8-9B11-40B0-BAB2-E5A2B3CCD0F0}"/>
                </a:ext>
              </a:extLst>
            </p:cNvPr>
            <p:cNvSpPr txBox="1"/>
            <p:nvPr/>
          </p:nvSpPr>
          <p:spPr>
            <a:xfrm>
              <a:off x="3207976" y="570402"/>
              <a:ext cx="733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C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ED88BB7-1B22-3917-7F81-5978CE6CE48E}"/>
                </a:ext>
              </a:extLst>
            </p:cNvPr>
            <p:cNvSpPr txBox="1"/>
            <p:nvPr/>
          </p:nvSpPr>
          <p:spPr>
            <a:xfrm>
              <a:off x="3992043" y="565241"/>
              <a:ext cx="12382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d6-GFP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TextBox 52">
            <a:extLst>
              <a:ext uri="{FF2B5EF4-FFF2-40B4-BE49-F238E27FC236}">
                <a16:creationId xmlns:a16="http://schemas.microsoft.com/office/drawing/2014/main" id="{4A989F89-BF31-03C3-E18F-E46BD3E3FC89}"/>
              </a:ext>
            </a:extLst>
          </p:cNvPr>
          <p:cNvSpPr txBox="1"/>
          <p:nvPr/>
        </p:nvSpPr>
        <p:spPr>
          <a:xfrm>
            <a:off x="5380417" y="2552701"/>
            <a:ext cx="9128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A20B4CC-A576-693C-2A68-9C84B6B0946E}"/>
              </a:ext>
            </a:extLst>
          </p:cNvPr>
          <p:cNvSpPr txBox="1"/>
          <p:nvPr/>
        </p:nvSpPr>
        <p:spPr>
          <a:xfrm>
            <a:off x="4721997" y="299084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49E2D533-DA07-7AF0-135F-F7853BDDE443}"/>
              </a:ext>
            </a:extLst>
          </p:cNvPr>
          <p:cNvCxnSpPr>
            <a:cxnSpLocks/>
          </p:cNvCxnSpPr>
          <p:nvPr/>
        </p:nvCxnSpPr>
        <p:spPr>
          <a:xfrm flipV="1">
            <a:off x="4203700" y="1885553"/>
            <a:ext cx="0" cy="144167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C8AA1401-C5E4-B7B2-5A67-2A974F7A6144}"/>
              </a:ext>
            </a:extLst>
          </p:cNvPr>
          <p:cNvCxnSpPr>
            <a:cxnSpLocks/>
          </p:cNvCxnSpPr>
          <p:nvPr/>
        </p:nvCxnSpPr>
        <p:spPr>
          <a:xfrm>
            <a:off x="3752269" y="1596854"/>
            <a:ext cx="76391" cy="13293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969026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8" name="Group 207">
            <a:extLst>
              <a:ext uri="{FF2B5EF4-FFF2-40B4-BE49-F238E27FC236}">
                <a16:creationId xmlns:a16="http://schemas.microsoft.com/office/drawing/2014/main" id="{45A9A8EC-6294-015E-83E7-B3AC695B96D7}"/>
              </a:ext>
            </a:extLst>
          </p:cNvPr>
          <p:cNvGrpSpPr/>
          <p:nvPr/>
        </p:nvGrpSpPr>
        <p:grpSpPr>
          <a:xfrm>
            <a:off x="259115" y="333477"/>
            <a:ext cx="2301686" cy="2385645"/>
            <a:chOff x="159354" y="4034257"/>
            <a:chExt cx="2301686" cy="2385645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C2D461D-0FD3-B87F-EE26-99D8EB7E1F09}"/>
                </a:ext>
              </a:extLst>
            </p:cNvPr>
            <p:cNvSpPr txBox="1"/>
            <p:nvPr/>
          </p:nvSpPr>
          <p:spPr>
            <a:xfrm rot="18584232">
              <a:off x="561629" y="5842709"/>
              <a:ext cx="7426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shocked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C53407F-C72B-0B5C-3EF4-549C6E86209D}"/>
                </a:ext>
              </a:extLst>
            </p:cNvPr>
            <p:cNvSpPr txBox="1"/>
            <p:nvPr/>
          </p:nvSpPr>
          <p:spPr>
            <a:xfrm rot="18584232">
              <a:off x="1200182" y="5838009"/>
              <a:ext cx="7426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shocked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247F5F0-CA0F-A0CF-2380-FB4238A4399F}"/>
                </a:ext>
              </a:extLst>
            </p:cNvPr>
            <p:cNvSpPr txBox="1"/>
            <p:nvPr/>
          </p:nvSpPr>
          <p:spPr>
            <a:xfrm rot="18584232">
              <a:off x="1433582" y="5859729"/>
              <a:ext cx="8607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cked 5.6M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6305B3A-6880-C6E6-885A-DF49A7131A14}"/>
                </a:ext>
              </a:extLst>
            </p:cNvPr>
            <p:cNvSpPr txBox="1"/>
            <p:nvPr/>
          </p:nvSpPr>
          <p:spPr>
            <a:xfrm rot="18584232">
              <a:off x="802370" y="5855530"/>
              <a:ext cx="8607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cked 5.6M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6028EBED-EF2F-C759-612D-0663B1CE4D54}"/>
                </a:ext>
              </a:extLst>
            </p:cNvPr>
            <p:cNvCxnSpPr>
              <a:cxnSpLocks/>
            </p:cNvCxnSpPr>
            <p:nvPr/>
          </p:nvCxnSpPr>
          <p:spPr>
            <a:xfrm>
              <a:off x="671991" y="6259380"/>
              <a:ext cx="51889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ED5645FF-A546-ED20-60D1-1A9DC16BFEB0}"/>
                </a:ext>
              </a:extLst>
            </p:cNvPr>
            <p:cNvCxnSpPr>
              <a:cxnSpLocks/>
            </p:cNvCxnSpPr>
            <p:nvPr/>
          </p:nvCxnSpPr>
          <p:spPr>
            <a:xfrm>
              <a:off x="1261978" y="6259469"/>
              <a:ext cx="51889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657AE4CB-2E88-DFC6-9B51-ADE26382EE63}"/>
                </a:ext>
              </a:extLst>
            </p:cNvPr>
            <p:cNvSpPr txBox="1"/>
            <p:nvPr/>
          </p:nvSpPr>
          <p:spPr>
            <a:xfrm>
              <a:off x="740492" y="6231545"/>
              <a:ext cx="3571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4EA3C3A7-5428-CDFE-181D-F537CBB53687}"/>
                </a:ext>
              </a:extLst>
            </p:cNvPr>
            <p:cNvSpPr txBox="1"/>
            <p:nvPr/>
          </p:nvSpPr>
          <p:spPr>
            <a:xfrm>
              <a:off x="1226797" y="6235236"/>
              <a:ext cx="81533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3∆lsm4∆C</a:t>
              </a:r>
              <a:endParaRPr lang="en-IN" sz="6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0" name="Picture 179">
              <a:extLst>
                <a:ext uri="{FF2B5EF4-FFF2-40B4-BE49-F238E27FC236}">
                  <a16:creationId xmlns:a16="http://schemas.microsoft.com/office/drawing/2014/main" id="{713E9B52-8A01-04F2-4E6D-9BE2AD95E79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31515" b="24456"/>
            <a:stretch/>
          </p:blipFill>
          <p:spPr>
            <a:xfrm>
              <a:off x="159354" y="4034257"/>
              <a:ext cx="2301686" cy="1809920"/>
            </a:xfrm>
            <a:prstGeom prst="rect">
              <a:avLst/>
            </a:prstGeom>
          </p:spPr>
        </p:pic>
      </p:grpSp>
      <p:grpSp>
        <p:nvGrpSpPr>
          <p:cNvPr id="209" name="Group 208">
            <a:extLst>
              <a:ext uri="{FF2B5EF4-FFF2-40B4-BE49-F238E27FC236}">
                <a16:creationId xmlns:a16="http://schemas.microsoft.com/office/drawing/2014/main" id="{B50387A9-7EB4-0B0E-BA6C-33D3881145C8}"/>
              </a:ext>
            </a:extLst>
          </p:cNvPr>
          <p:cNvGrpSpPr/>
          <p:nvPr/>
        </p:nvGrpSpPr>
        <p:grpSpPr>
          <a:xfrm>
            <a:off x="2475507" y="348140"/>
            <a:ext cx="2297757" cy="2385454"/>
            <a:chOff x="2375746" y="4048920"/>
            <a:chExt cx="2297757" cy="2385454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94D975E1-305A-9FEA-2558-D0E5D88E2FFE}"/>
                </a:ext>
              </a:extLst>
            </p:cNvPr>
            <p:cNvSpPr txBox="1"/>
            <p:nvPr/>
          </p:nvSpPr>
          <p:spPr>
            <a:xfrm rot="18584232">
              <a:off x="2814947" y="5793628"/>
              <a:ext cx="7426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shocked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66F0F8A-390F-6408-FEB8-B866C716EFE8}"/>
                </a:ext>
              </a:extLst>
            </p:cNvPr>
            <p:cNvSpPr txBox="1"/>
            <p:nvPr/>
          </p:nvSpPr>
          <p:spPr>
            <a:xfrm rot="18584232">
              <a:off x="3475502" y="5784962"/>
              <a:ext cx="7426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shocked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A303339E-EA3C-63A0-625F-4F288AC318A0}"/>
                </a:ext>
              </a:extLst>
            </p:cNvPr>
            <p:cNvSpPr txBox="1"/>
            <p:nvPr/>
          </p:nvSpPr>
          <p:spPr>
            <a:xfrm rot="18584232">
              <a:off x="3664827" y="5835149"/>
              <a:ext cx="8607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cked 5.6M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01FF0FFD-A092-642F-02A9-5C9AAB060FC0}"/>
                </a:ext>
              </a:extLst>
            </p:cNvPr>
            <p:cNvSpPr txBox="1"/>
            <p:nvPr/>
          </p:nvSpPr>
          <p:spPr>
            <a:xfrm rot="18584232">
              <a:off x="3034637" y="5837497"/>
              <a:ext cx="8607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cked 5.6M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0516E48C-A93B-9360-4591-912D48E3E166}"/>
                </a:ext>
              </a:extLst>
            </p:cNvPr>
            <p:cNvCxnSpPr>
              <a:cxnSpLocks/>
            </p:cNvCxnSpPr>
            <p:nvPr/>
          </p:nvCxnSpPr>
          <p:spPr>
            <a:xfrm>
              <a:off x="2951511" y="6253965"/>
              <a:ext cx="51889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E7468740-B7D0-9909-BBB1-453676FF333E}"/>
                </a:ext>
              </a:extLst>
            </p:cNvPr>
            <p:cNvSpPr txBox="1"/>
            <p:nvPr/>
          </p:nvSpPr>
          <p:spPr>
            <a:xfrm>
              <a:off x="3086068" y="6241568"/>
              <a:ext cx="3571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en-IN" sz="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AE198A8B-7262-2D43-5772-A2AFC2FAE091}"/>
                </a:ext>
              </a:extLst>
            </p:cNvPr>
            <p:cNvSpPr txBox="1"/>
            <p:nvPr/>
          </p:nvSpPr>
          <p:spPr>
            <a:xfrm>
              <a:off x="3494622" y="6249708"/>
              <a:ext cx="81533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3∆lsm4∆C</a:t>
              </a:r>
              <a:endParaRPr lang="en-IN" sz="6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CBCBA9FC-0032-2EBB-013E-435A12E9B109}"/>
                </a:ext>
              </a:extLst>
            </p:cNvPr>
            <p:cNvCxnSpPr>
              <a:cxnSpLocks/>
            </p:cNvCxnSpPr>
            <p:nvPr/>
          </p:nvCxnSpPr>
          <p:spPr>
            <a:xfrm>
              <a:off x="3551692" y="6251727"/>
              <a:ext cx="51889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id="{E198AA75-9207-1DC2-974C-63F89D7422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18205" b="31356"/>
            <a:stretch/>
          </p:blipFill>
          <p:spPr>
            <a:xfrm>
              <a:off x="2375746" y="4048920"/>
              <a:ext cx="2297757" cy="1774995"/>
            </a:xfrm>
            <a:prstGeom prst="rect">
              <a:avLst/>
            </a:prstGeom>
          </p:spPr>
        </p:pic>
      </p:grpSp>
      <p:grpSp>
        <p:nvGrpSpPr>
          <p:cNvPr id="207" name="Group 206">
            <a:extLst>
              <a:ext uri="{FF2B5EF4-FFF2-40B4-BE49-F238E27FC236}">
                <a16:creationId xmlns:a16="http://schemas.microsoft.com/office/drawing/2014/main" id="{34E4770E-925F-87B6-83E5-D3CFE8697D3C}"/>
              </a:ext>
            </a:extLst>
          </p:cNvPr>
          <p:cNvGrpSpPr/>
          <p:nvPr/>
        </p:nvGrpSpPr>
        <p:grpSpPr>
          <a:xfrm>
            <a:off x="4621916" y="401943"/>
            <a:ext cx="2236084" cy="2222543"/>
            <a:chOff x="4522155" y="4102723"/>
            <a:chExt cx="2236084" cy="2222543"/>
          </a:xfrm>
        </p:grpSpPr>
        <p:pic>
          <p:nvPicPr>
            <p:cNvPr id="184" name="Picture 183">
              <a:extLst>
                <a:ext uri="{FF2B5EF4-FFF2-40B4-BE49-F238E27FC236}">
                  <a16:creationId xmlns:a16="http://schemas.microsoft.com/office/drawing/2014/main" id="{CFAF60E9-91A3-8A92-F3E8-9A831E445B7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21534" b="32208"/>
            <a:stretch/>
          </p:blipFill>
          <p:spPr>
            <a:xfrm>
              <a:off x="4522155" y="4102723"/>
              <a:ext cx="2236084" cy="1700554"/>
            </a:xfrm>
            <a:prstGeom prst="rect">
              <a:avLst/>
            </a:prstGeom>
          </p:spPr>
        </p:pic>
        <p:grpSp>
          <p:nvGrpSpPr>
            <p:cNvPr id="197" name="Group 196">
              <a:extLst>
                <a:ext uri="{FF2B5EF4-FFF2-40B4-BE49-F238E27FC236}">
                  <a16:creationId xmlns:a16="http://schemas.microsoft.com/office/drawing/2014/main" id="{22E1F416-A6C2-E936-E25E-3CE7F3209865}"/>
                </a:ext>
              </a:extLst>
            </p:cNvPr>
            <p:cNvGrpSpPr/>
            <p:nvPr/>
          </p:nvGrpSpPr>
          <p:grpSpPr>
            <a:xfrm>
              <a:off x="5003113" y="5353884"/>
              <a:ext cx="1375937" cy="971382"/>
              <a:chOff x="5003113" y="5353884"/>
              <a:chExt cx="1375937" cy="971382"/>
            </a:xfrm>
          </p:grpSpPr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4C0EEBF0-3EA6-A8E8-5E68-F37C7C1F66BD}"/>
                  </a:ext>
                </a:extLst>
              </p:cNvPr>
              <p:cNvSpPr txBox="1"/>
              <p:nvPr/>
            </p:nvSpPr>
            <p:spPr>
              <a:xfrm rot="18584232">
                <a:off x="4891253" y="5750990"/>
                <a:ext cx="7426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treated</a:t>
                </a:r>
                <a:endParaRPr lang="en-IN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4F9A553A-29BA-97D9-1C27-D8B9A803F092}"/>
                  </a:ext>
                </a:extLst>
              </p:cNvPr>
              <p:cNvSpPr txBox="1"/>
              <p:nvPr/>
            </p:nvSpPr>
            <p:spPr>
              <a:xfrm rot="18584232">
                <a:off x="5531303" y="5761373"/>
                <a:ext cx="74261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treated</a:t>
                </a:r>
                <a:endParaRPr lang="en-IN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EE0E9B66-0D24-9FFE-F787-CA5D6792F1C8}"/>
                  </a:ext>
                </a:extLst>
              </p:cNvPr>
              <p:cNvSpPr txBox="1"/>
              <p:nvPr/>
            </p:nvSpPr>
            <p:spPr>
              <a:xfrm rot="18584232">
                <a:off x="5844523" y="5691927"/>
                <a:ext cx="86075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ClO4</a:t>
                </a:r>
                <a:endParaRPr lang="en-IN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C4C1D1F7-F8F9-0983-245E-703AAD5885E5}"/>
                  </a:ext>
                </a:extLst>
              </p:cNvPr>
              <p:cNvSpPr txBox="1"/>
              <p:nvPr/>
            </p:nvSpPr>
            <p:spPr>
              <a:xfrm rot="18584232">
                <a:off x="5285032" y="5835148"/>
                <a:ext cx="46941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aClO4</a:t>
                </a:r>
                <a:endParaRPr lang="en-IN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EBDF3465-421F-EF6B-5807-66B88E8AEA2A}"/>
                  </a:ext>
                </a:extLst>
              </p:cNvPr>
              <p:cNvSpPr txBox="1"/>
              <p:nvPr/>
            </p:nvSpPr>
            <p:spPr>
              <a:xfrm>
                <a:off x="5093494" y="6139212"/>
                <a:ext cx="35718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en-IN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EBECC382-4974-F024-21A6-DEB6A8C93AFD}"/>
                  </a:ext>
                </a:extLst>
              </p:cNvPr>
              <p:cNvSpPr txBox="1"/>
              <p:nvPr/>
            </p:nvSpPr>
            <p:spPr>
              <a:xfrm>
                <a:off x="5563713" y="6140600"/>
                <a:ext cx="81533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3∆lsm4∆C</a:t>
                </a:r>
                <a:endParaRPr lang="en-IN" sz="6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1" name="Straight Connector 190">
                <a:extLst>
                  <a:ext uri="{FF2B5EF4-FFF2-40B4-BE49-F238E27FC236}">
                    <a16:creationId xmlns:a16="http://schemas.microsoft.com/office/drawing/2014/main" id="{BAE4F949-351F-8158-2895-699F252C26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29787" y="6151939"/>
                <a:ext cx="51889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>
                <a:extLst>
                  <a:ext uri="{FF2B5EF4-FFF2-40B4-BE49-F238E27FC236}">
                    <a16:creationId xmlns:a16="http://schemas.microsoft.com/office/drawing/2014/main" id="{EF7262F4-C874-4110-58E1-E1D7080E61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03113" y="6155540"/>
                <a:ext cx="51889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09D5B58C-B4FB-E388-D0D2-7978C23E20E8}"/>
              </a:ext>
            </a:extLst>
          </p:cNvPr>
          <p:cNvSpPr txBox="1"/>
          <p:nvPr/>
        </p:nvSpPr>
        <p:spPr>
          <a:xfrm>
            <a:off x="72546" y="145703"/>
            <a:ext cx="373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D2C0D78-3453-E4EC-A6AA-8452082E68BE}"/>
              </a:ext>
            </a:extLst>
          </p:cNvPr>
          <p:cNvSpPr txBox="1"/>
          <p:nvPr/>
        </p:nvSpPr>
        <p:spPr>
          <a:xfrm>
            <a:off x="2473824" y="151523"/>
            <a:ext cx="373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EA2B0AE-4DD2-2AD0-E9D6-DFA19CCD3F3B}"/>
              </a:ext>
            </a:extLst>
          </p:cNvPr>
          <p:cNvSpPr txBox="1"/>
          <p:nvPr/>
        </p:nvSpPr>
        <p:spPr>
          <a:xfrm>
            <a:off x="4599641" y="145702"/>
            <a:ext cx="3731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 Box 2">
            <a:extLst>
              <a:ext uri="{FF2B5EF4-FFF2-40B4-BE49-F238E27FC236}">
                <a16:creationId xmlns:a16="http://schemas.microsoft.com/office/drawing/2014/main" id="{41542ABA-E98F-4A0B-E387-11393652163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6872" y="2845820"/>
            <a:ext cx="6515100" cy="30068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IN" sz="10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IN" sz="1000" b="1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IN" sz="10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edc3∆lsm4∆C mutant is defective in condensate assembly and demonstrates an extended lag phase in sodium perchlorate stress</a:t>
            </a:r>
            <a:r>
              <a:rPr lang="en-IN" sz="1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Quantification for the </a:t>
            </a:r>
            <a:r>
              <a:rPr lang="en-IN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number of granules obtained from 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icroscopy analysis for </a:t>
            </a:r>
            <a:r>
              <a:rPr lang="en-IN" sz="10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dc3∆lsm4∆C 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tant strain upon exposure to 5.6 Mach intensity shock waves and continuous sodium perchlorate (NaClO4) treatment, as shown in Figure 3A-B. Dcp2-mCherry and Pab1-GFP are the markers of P-bodies and stress granules, respectively. [A] Pab1-GFP granules upon exposure to 5.6M </a:t>
            </a:r>
            <a:r>
              <a:rPr lang="en-IN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tensity shock wave, [B]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Dcp2-mCherry granules upon exposure to 5.6M </a:t>
            </a:r>
            <a:r>
              <a:rPr lang="en-IN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tensity shock wave, [C] 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cp2-mCherry granules </a:t>
            </a:r>
            <a:r>
              <a:rPr lang="en-IN" sz="1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upon continuous NaClO4 treatment. In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bove experiments, error bars represent the Standard Error of the Mean. The significance of the data was calculated by Tukey’s multiple comparison test with p-values summarized as : </a:t>
            </a:r>
            <a:r>
              <a:rPr lang="en-IN" sz="10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***</a:t>
            </a:r>
            <a:r>
              <a:rPr lang="en-IN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p &lt; 0.0001.  The quantification of wildtype in all 3 graph shown above is same as shown in Figure 2B, 2C, and 2E as the experiments were performed at the same time. </a:t>
            </a:r>
          </a:p>
        </p:txBody>
      </p:sp>
    </p:spTree>
    <p:extLst>
      <p:ext uri="{BB962C8B-B14F-4D97-AF65-F5344CB8AC3E}">
        <p14:creationId xmlns:p14="http://schemas.microsoft.com/office/powerpoint/2010/main" val="29571825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7A8B9E31-928C-9FBE-3B33-2D9BB0F7E3E7}"/>
              </a:ext>
            </a:extLst>
          </p:cNvPr>
          <p:cNvGrpSpPr/>
          <p:nvPr/>
        </p:nvGrpSpPr>
        <p:grpSpPr>
          <a:xfrm>
            <a:off x="514756" y="3282999"/>
            <a:ext cx="2223000" cy="2366202"/>
            <a:chOff x="4659029" y="2288480"/>
            <a:chExt cx="1627803" cy="1736968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F8E1A7B-9EAE-1950-DCFF-8D086515B89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8606" t="9808" r="22982" b="49633"/>
            <a:stretch/>
          </p:blipFill>
          <p:spPr>
            <a:xfrm>
              <a:off x="4826858" y="2288480"/>
              <a:ext cx="1305947" cy="1147620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9387008-2E18-10C3-6C29-075B66E13B16}"/>
                </a:ext>
              </a:extLst>
            </p:cNvPr>
            <p:cNvSpPr txBox="1"/>
            <p:nvPr/>
          </p:nvSpPr>
          <p:spPr>
            <a:xfrm rot="19457076">
              <a:off x="4964268" y="3426463"/>
              <a:ext cx="348206" cy="158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94150FB-2142-D3F4-7D0C-5C5D27C50648}"/>
                </a:ext>
              </a:extLst>
            </p:cNvPr>
            <p:cNvSpPr txBox="1"/>
            <p:nvPr/>
          </p:nvSpPr>
          <p:spPr>
            <a:xfrm rot="19457076">
              <a:off x="4992040" y="3506130"/>
              <a:ext cx="637633" cy="158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3∆lsm4∆C 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1AFFDE0-8457-FC98-A8DD-50802D87366D}"/>
                </a:ext>
              </a:extLst>
            </p:cNvPr>
            <p:cNvSpPr txBox="1"/>
            <p:nvPr/>
          </p:nvSpPr>
          <p:spPr>
            <a:xfrm rot="19457076">
              <a:off x="5509807" y="3412219"/>
              <a:ext cx="348206" cy="158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A78A58A-EDBA-CAE3-48FE-83FCAAA7315A}"/>
                </a:ext>
              </a:extLst>
            </p:cNvPr>
            <p:cNvSpPr txBox="1"/>
            <p:nvPr/>
          </p:nvSpPr>
          <p:spPr>
            <a:xfrm rot="19457076">
              <a:off x="5479692" y="3496906"/>
              <a:ext cx="637633" cy="158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3∆lsm4∆C 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7C15B64F-3D91-D342-AD74-33E5781A6E5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23570" y="3779084"/>
              <a:ext cx="421932" cy="2354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F442027-CACF-1014-5F3D-FFE657C5AFFC}"/>
                </a:ext>
              </a:extLst>
            </p:cNvPr>
            <p:cNvSpPr txBox="1"/>
            <p:nvPr/>
          </p:nvSpPr>
          <p:spPr>
            <a:xfrm>
              <a:off x="4983130" y="3790613"/>
              <a:ext cx="600910" cy="1581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treated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0BAA7A95-5272-C5CC-2E9C-98D2BE79C4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25465" y="3778999"/>
              <a:ext cx="691703" cy="243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43D2C5F-0F40-98AC-59C6-98529D6FD32B}"/>
                </a:ext>
              </a:extLst>
            </p:cNvPr>
            <p:cNvSpPr txBox="1"/>
            <p:nvPr/>
          </p:nvSpPr>
          <p:spPr>
            <a:xfrm>
              <a:off x="5466827" y="3776924"/>
              <a:ext cx="820005" cy="2485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cked + NaClO4</a:t>
              </a:r>
            </a:p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eated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1A5BFD7-A52D-E543-C40B-DF8104102845}"/>
                </a:ext>
              </a:extLst>
            </p:cNvPr>
            <p:cNvSpPr txBox="1"/>
            <p:nvPr/>
          </p:nvSpPr>
          <p:spPr>
            <a:xfrm rot="16200000">
              <a:off x="4342278" y="2707271"/>
              <a:ext cx="8489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n lag time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13" name="Picture 112">
            <a:extLst>
              <a:ext uri="{FF2B5EF4-FFF2-40B4-BE49-F238E27FC236}">
                <a16:creationId xmlns:a16="http://schemas.microsoft.com/office/drawing/2014/main" id="{B2292F28-D81C-2E86-8640-E669A68CA9B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851" t="24278" r="1612" b="2455"/>
          <a:stretch/>
        </p:blipFill>
        <p:spPr>
          <a:xfrm>
            <a:off x="440732" y="352611"/>
            <a:ext cx="6263392" cy="2551228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B9A55C49-40FE-9B2A-03D2-F981A25C8534}"/>
              </a:ext>
            </a:extLst>
          </p:cNvPr>
          <p:cNvGrpSpPr/>
          <p:nvPr/>
        </p:nvGrpSpPr>
        <p:grpSpPr>
          <a:xfrm>
            <a:off x="3720076" y="3132808"/>
            <a:ext cx="1797655" cy="2639504"/>
            <a:chOff x="4285226" y="3739816"/>
            <a:chExt cx="1797655" cy="2639504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DF2FBB4-8E1A-2FB5-2EC2-8697FCDF164F}"/>
                </a:ext>
              </a:extLst>
            </p:cNvPr>
            <p:cNvSpPr txBox="1"/>
            <p:nvPr/>
          </p:nvSpPr>
          <p:spPr>
            <a:xfrm rot="19371946">
              <a:off x="4541956" y="5507785"/>
              <a:ext cx="10239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inuous NaClO4 treated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A6DCC99-3182-56D5-1523-1604700EB325}"/>
                </a:ext>
              </a:extLst>
            </p:cNvPr>
            <p:cNvSpPr txBox="1"/>
            <p:nvPr/>
          </p:nvSpPr>
          <p:spPr>
            <a:xfrm rot="16200000">
              <a:off x="3701509" y="4323533"/>
              <a:ext cx="156754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difference in mean lag time</a:t>
              </a:r>
              <a:endParaRPr lang="en-IN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7361AA45-68FC-AE3B-4C78-7215E66CE659}"/>
                </a:ext>
              </a:extLst>
            </p:cNvPr>
            <p:cNvSpPr txBox="1"/>
            <p:nvPr/>
          </p:nvSpPr>
          <p:spPr>
            <a:xfrm rot="19371946">
              <a:off x="5107706" y="5473330"/>
              <a:ext cx="97517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ck wave</a:t>
              </a:r>
            </a:p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Continuous NaClO4 treated</a:t>
              </a:r>
              <a:endParaRPr lang="en-I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BB519D4C-7CB0-4419-8D5B-3ECBC4C1DC0E}"/>
                </a:ext>
              </a:extLst>
            </p:cNvPr>
            <p:cNvCxnSpPr/>
            <p:nvPr/>
          </p:nvCxnSpPr>
          <p:spPr>
            <a:xfrm>
              <a:off x="4755225" y="6121092"/>
              <a:ext cx="103833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CB1BE52E-033B-628E-5E84-33FCBB9A474E}"/>
                </a:ext>
              </a:extLst>
            </p:cNvPr>
            <p:cNvSpPr txBox="1"/>
            <p:nvPr/>
          </p:nvSpPr>
          <p:spPr>
            <a:xfrm>
              <a:off x="4782571" y="6133099"/>
              <a:ext cx="9671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3∆lsm4∆C</a:t>
              </a:r>
            </a:p>
          </p:txBody>
        </p:sp>
        <p:pic>
          <p:nvPicPr>
            <p:cNvPr id="78" name="Picture 77">
              <a:extLst>
                <a:ext uri="{FF2B5EF4-FFF2-40B4-BE49-F238E27FC236}">
                  <a16:creationId xmlns:a16="http://schemas.microsoft.com/office/drawing/2014/main" id="{874CDBD8-AD64-FFA0-552B-EAC5F26FC4D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4789" t="11166" r="16643" b="40878"/>
            <a:stretch/>
          </p:blipFill>
          <p:spPr>
            <a:xfrm>
              <a:off x="4687429" y="3781614"/>
              <a:ext cx="1312256" cy="1670636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626F02B-C739-AAB9-FF2E-5F89BCE446FE}"/>
              </a:ext>
            </a:extLst>
          </p:cNvPr>
          <p:cNvSpPr txBox="1"/>
          <p:nvPr/>
        </p:nvSpPr>
        <p:spPr>
          <a:xfrm>
            <a:off x="43132" y="229500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C4BF38-7F10-DD55-75EA-7DB43282C5C1}"/>
              </a:ext>
            </a:extLst>
          </p:cNvPr>
          <p:cNvSpPr txBox="1"/>
          <p:nvPr/>
        </p:nvSpPr>
        <p:spPr>
          <a:xfrm>
            <a:off x="43132" y="2940731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J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261B8E7-E0F8-3A08-1D15-E22D22755B9F}"/>
              </a:ext>
            </a:extLst>
          </p:cNvPr>
          <p:cNvSpPr txBox="1"/>
          <p:nvPr/>
        </p:nvSpPr>
        <p:spPr>
          <a:xfrm>
            <a:off x="3320384" y="2940730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 Box 2">
            <a:extLst>
              <a:ext uri="{FF2B5EF4-FFF2-40B4-BE49-F238E27FC236}">
                <a16:creationId xmlns:a16="http://schemas.microsoft.com/office/drawing/2014/main" id="{1530C273-3A6D-A312-9F36-2F0817D69DC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87" y="5954136"/>
            <a:ext cx="6753225" cy="99164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000" b="1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3: </a:t>
            </a:r>
            <a:r>
              <a:rPr lang="en-US" sz="1000" b="1" i="1" kern="1200" dirty="0">
                <a:solidFill>
                  <a:srgbClr val="000000"/>
                </a:solidFill>
                <a:effectLst>
                  <a:outerShdw sx="0" sy="0">
                    <a:srgbClr val="000000"/>
                  </a:outerShdw>
                </a:effectLst>
                <a:latin typeface="Times New Roman" panose="02020603050405020304" pitchFamily="18" charset="0"/>
                <a:ea typeface="SimSun" panose="02010600030101010101" pitchFamily="2" charset="-122"/>
              </a:rPr>
              <a:t>edc3∆lsm4∆C mutant demonstrates delayed log phase </a:t>
            </a:r>
            <a:r>
              <a:rPr lang="en-US" sz="1000" b="1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in combined stress of sodium perchlorate and shock waves.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[A]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Comparison of the growth curve for wildtype and 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mutant post-exposure to 5.6M intensity shock wave grown in the presence of 100mM of sodium perchlorate.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[B]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Graph depicting </a:t>
            </a:r>
            <a:r>
              <a:rPr lang="en-US" sz="1000" kern="0" dirty="0">
                <a:latin typeface="Times New Roman" panose="02020603050405020304" pitchFamily="18" charset="0"/>
                <a:ea typeface="SimSun" panose="02010600030101010101" pitchFamily="2" charset="-122"/>
              </a:rPr>
              <a:t>the m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an lag time for wild-type and 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 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mutant obtained from supplementary figure [A]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. [C]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Graph depicting the relative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difference in mean lag time 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for 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 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in perchlorate stress alone and in combination with shock waves with respect to wild-type obtained from Figure 3D and supplementary figure 2B.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IN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he significance of the data was calculated by Tukey’s multiple comparison test for growth curves with </a:t>
            </a:r>
            <a:r>
              <a:rPr lang="en-IN" sz="1000" i="1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-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values summarized as: 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p &lt;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0.05 *.  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algn="just"/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 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6491573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3BA7B18-13A3-BA58-FEBC-2F87C33AE7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100" y="726206"/>
            <a:ext cx="3237857" cy="344207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ED55F0C-9013-4E39-D1ED-3BB56D0301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5044" y="726206"/>
            <a:ext cx="3238075" cy="344207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5DCE8D8-7212-C1E2-4BEB-3AB6922D89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02956" y="5789857"/>
            <a:ext cx="3187186" cy="341669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5FBC018-E096-BB7F-1B7A-21209A80436F}"/>
              </a:ext>
            </a:extLst>
          </p:cNvPr>
          <p:cNvSpPr txBox="1"/>
          <p:nvPr/>
        </p:nvSpPr>
        <p:spPr>
          <a:xfrm>
            <a:off x="0" y="382074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786BBC-ADD3-3E37-F179-B5D05BB34D55}"/>
              </a:ext>
            </a:extLst>
          </p:cNvPr>
          <p:cNvSpPr txBox="1"/>
          <p:nvPr/>
        </p:nvSpPr>
        <p:spPr>
          <a:xfrm>
            <a:off x="3429000" y="382073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C7855D1-1922-F41E-A537-6929DE85AC05}"/>
              </a:ext>
            </a:extLst>
          </p:cNvPr>
          <p:cNvSpPr txBox="1"/>
          <p:nvPr/>
        </p:nvSpPr>
        <p:spPr>
          <a:xfrm>
            <a:off x="0" y="5228510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8E486D0-8818-A681-57BE-F785F9B86070}"/>
              </a:ext>
            </a:extLst>
          </p:cNvPr>
          <p:cNvSpPr txBox="1"/>
          <p:nvPr/>
        </p:nvSpPr>
        <p:spPr>
          <a:xfrm>
            <a:off x="3429000" y="5228509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19F2689-997E-7380-3A08-03022079369D}"/>
              </a:ext>
            </a:extLst>
          </p:cNvPr>
          <p:cNvSpPr txBox="1"/>
          <p:nvPr/>
        </p:nvSpPr>
        <p:spPr>
          <a:xfrm>
            <a:off x="276225" y="390628"/>
            <a:ext cx="31267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treated vs  NaClO4 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D157C57-926D-08E8-A29D-B86293F518B0}"/>
              </a:ext>
            </a:extLst>
          </p:cNvPr>
          <p:cNvSpPr txBox="1"/>
          <p:nvPr/>
        </p:nvSpPr>
        <p:spPr>
          <a:xfrm>
            <a:off x="3672106" y="390628"/>
            <a:ext cx="3020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treated vs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0D89412-2E36-C603-5D29-4DB77F603A56}"/>
              </a:ext>
            </a:extLst>
          </p:cNvPr>
          <p:cNvSpPr txBox="1"/>
          <p:nvPr/>
        </p:nvSpPr>
        <p:spPr>
          <a:xfrm>
            <a:off x="3672106" y="5241226"/>
            <a:ext cx="29180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vs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ClO4 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7A142BE8-7F4C-B911-1715-12CE30FD77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6935" y="5789857"/>
            <a:ext cx="3216021" cy="339958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16556EF-B5FC-4E7B-0470-72C5B8BC052E}"/>
              </a:ext>
            </a:extLst>
          </p:cNvPr>
          <p:cNvSpPr txBox="1"/>
          <p:nvPr/>
        </p:nvSpPr>
        <p:spPr>
          <a:xfrm>
            <a:off x="165100" y="5226428"/>
            <a:ext cx="312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 vs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ClO4 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8524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ED01F4A-1051-625D-75CE-4C9C04A377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9101" y="204914"/>
            <a:ext cx="1911350" cy="192757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36D25C9-DA04-1365-B3D2-6C46C32E0C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9101" y="2234085"/>
            <a:ext cx="1949444" cy="192757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423B147-9AE2-F5F0-FABF-33AABAAA124A}"/>
              </a:ext>
            </a:extLst>
          </p:cNvPr>
          <p:cNvSpPr txBox="1"/>
          <p:nvPr/>
        </p:nvSpPr>
        <p:spPr>
          <a:xfrm>
            <a:off x="0" y="73970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715B121-B3F3-ED1D-35F9-F26D024BDED8}"/>
              </a:ext>
            </a:extLst>
          </p:cNvPr>
          <p:cNvSpPr txBox="1"/>
          <p:nvPr/>
        </p:nvSpPr>
        <p:spPr>
          <a:xfrm>
            <a:off x="3831501" y="73969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6A49DC-5906-1684-3AAA-C95B39E1D111}"/>
              </a:ext>
            </a:extLst>
          </p:cNvPr>
          <p:cNvSpPr txBox="1"/>
          <p:nvPr/>
        </p:nvSpPr>
        <p:spPr>
          <a:xfrm>
            <a:off x="3831501" y="2034691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364F70B-673A-E27C-2BDE-AB04EE36FFD1}"/>
              </a:ext>
            </a:extLst>
          </p:cNvPr>
          <p:cNvSpPr txBox="1"/>
          <p:nvPr/>
        </p:nvSpPr>
        <p:spPr>
          <a:xfrm>
            <a:off x="4100390" y="2066580"/>
            <a:ext cx="2156072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1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dc3</a:t>
            </a:r>
            <a:r>
              <a:rPr lang="en-US" sz="619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61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619" b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61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untreated vs </a:t>
            </a:r>
            <a:r>
              <a:rPr lang="en-US" sz="619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</a:t>
            </a:r>
            <a:r>
              <a:rPr lang="en-US" sz="619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619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619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619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61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ClO4 treated</a:t>
            </a:r>
            <a:endParaRPr lang="en-IN" sz="6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A1635BE-2312-0B54-2A9B-6CA8C7E29EBC}"/>
              </a:ext>
            </a:extLst>
          </p:cNvPr>
          <p:cNvSpPr txBox="1"/>
          <p:nvPr/>
        </p:nvSpPr>
        <p:spPr>
          <a:xfrm>
            <a:off x="4398840" y="105028"/>
            <a:ext cx="1667765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1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treated vs </a:t>
            </a:r>
            <a:r>
              <a:rPr lang="en-US" sz="619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∆lsm4∆C </a:t>
            </a:r>
            <a:r>
              <a:rPr lang="en-US" sz="61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endParaRPr lang="en-IN" sz="6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375BF9D-3A15-EB53-7B00-2303AB2F3EE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027" y="352678"/>
            <a:ext cx="3479463" cy="370317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AA2347B-F16C-D622-861A-41E9681C6F91}"/>
              </a:ext>
            </a:extLst>
          </p:cNvPr>
          <p:cNvSpPr txBox="1"/>
          <p:nvPr/>
        </p:nvSpPr>
        <p:spPr>
          <a:xfrm>
            <a:off x="289755" y="73969"/>
            <a:ext cx="3425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shocked vs WT shock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 Box 2">
            <a:extLst>
              <a:ext uri="{FF2B5EF4-FFF2-40B4-BE49-F238E27FC236}">
                <a16:creationId xmlns:a16="http://schemas.microsoft.com/office/drawing/2014/main" id="{10E4EFE3-52A8-5D71-BE2B-D51CE19DB7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061" y="4263256"/>
            <a:ext cx="6499878" cy="171065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000" b="1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4: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Heat map showing expression profiles of the top 20 significant differentially expressed genes in [A] wild-type untreated vs NaClO4 treated cells; [B] wild-type vs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untreated cells; [C]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untreated vs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NaClO4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reated cells; [D] wild-type un vs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NaClO4 treated cells; [E] wild-type unshocked vs shocked. [F-G] Volcano plot showing changes in transcript levels in [F] wild-type vs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untreated cells; [G]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edc3∆lsm4∆C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untreated vs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NaClO4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treated cells. </a:t>
            </a:r>
            <a:r>
              <a:rPr lang="en-IN" sz="10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0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dots represent up-regulated transcripts having log2fc &gt;0.05, the red dots represent down-regulated transcripts having log2fc &lt;0.05, and neutrally expressed transcripts are represented as black. 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9722332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81D48FD-BF32-1D9F-2F4D-ABBA1EE95B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753" y="576580"/>
            <a:ext cx="3322247" cy="166000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DA56007-6975-F2D2-5A4B-4470D5A26F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5752" y="576581"/>
            <a:ext cx="3322248" cy="167116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A7D8E2E-AA10-1097-92E5-F8E9A59F3C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6753" y="3060487"/>
            <a:ext cx="3322247" cy="164450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5E4E6CF-335E-04C8-8833-E128F24663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43372" y="3068106"/>
            <a:ext cx="3322248" cy="164450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8A6B1378-EE41-1C85-321C-2A5297E21A3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4990" y="5489765"/>
            <a:ext cx="3429000" cy="168592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649EAC2-99F6-0737-80DA-8DE8AEFD349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61609" y="5485008"/>
            <a:ext cx="3408659" cy="168727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E209A3A-062B-6A9D-4A36-81B720CD2D9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190" y="7928558"/>
            <a:ext cx="3368468" cy="1666206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6AF9649F-6A74-7689-E3ED-14740FAAC40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70438" y="7973256"/>
            <a:ext cx="3291838" cy="1632716"/>
          </a:xfrm>
          <a:prstGeom prst="rect">
            <a:avLst/>
          </a:prstGeom>
        </p:spPr>
      </p:pic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A6892300-7E29-4DF5-3715-92FA9D468713}"/>
              </a:ext>
            </a:extLst>
          </p:cNvPr>
          <p:cNvCxnSpPr>
            <a:cxnSpLocks/>
          </p:cNvCxnSpPr>
          <p:nvPr/>
        </p:nvCxnSpPr>
        <p:spPr>
          <a:xfrm flipV="1">
            <a:off x="55244" y="5204771"/>
            <a:ext cx="6666820" cy="75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240E025-54B1-0C7C-9AAF-F1FC03DD455C}"/>
              </a:ext>
            </a:extLst>
          </p:cNvPr>
          <p:cNvCxnSpPr>
            <a:cxnSpLocks/>
          </p:cNvCxnSpPr>
          <p:nvPr/>
        </p:nvCxnSpPr>
        <p:spPr>
          <a:xfrm>
            <a:off x="57190" y="7712607"/>
            <a:ext cx="676746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B1E5FC0-0DB6-67FC-B61E-57E9F0752DC6}"/>
              </a:ext>
            </a:extLst>
          </p:cNvPr>
          <p:cNvCxnSpPr>
            <a:cxnSpLocks/>
          </p:cNvCxnSpPr>
          <p:nvPr/>
        </p:nvCxnSpPr>
        <p:spPr>
          <a:xfrm>
            <a:off x="143875" y="2705246"/>
            <a:ext cx="66751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B1068D1C-07FE-B25F-ED5E-18CC8AFA152B}"/>
              </a:ext>
            </a:extLst>
          </p:cNvPr>
          <p:cNvCxnSpPr>
            <a:cxnSpLocks/>
          </p:cNvCxnSpPr>
          <p:nvPr/>
        </p:nvCxnSpPr>
        <p:spPr>
          <a:xfrm>
            <a:off x="123280" y="322580"/>
            <a:ext cx="65670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19F354BB-5284-C3D0-9E42-7C6E72AF351D}"/>
              </a:ext>
            </a:extLst>
          </p:cNvPr>
          <p:cNvSpPr txBox="1"/>
          <p:nvPr/>
        </p:nvSpPr>
        <p:spPr>
          <a:xfrm>
            <a:off x="0" y="0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872804F-8B8E-6984-014D-26A1377FA37E}"/>
              </a:ext>
            </a:extLst>
          </p:cNvPr>
          <p:cNvSpPr txBox="1"/>
          <p:nvPr/>
        </p:nvSpPr>
        <p:spPr>
          <a:xfrm>
            <a:off x="2156240" y="48748"/>
            <a:ext cx="21742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treated vs  NaClO4 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42F07CF-83F0-9F50-CC2C-A6F40AFB1637}"/>
              </a:ext>
            </a:extLst>
          </p:cNvPr>
          <p:cNvSpPr txBox="1"/>
          <p:nvPr/>
        </p:nvSpPr>
        <p:spPr>
          <a:xfrm>
            <a:off x="-91366" y="331192"/>
            <a:ext cx="3527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upregulated transcripts based on Biological processes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F12F7F-20D9-238E-5CB7-B6677975EC16}"/>
              </a:ext>
            </a:extLst>
          </p:cNvPr>
          <p:cNvSpPr txBox="1"/>
          <p:nvPr/>
        </p:nvSpPr>
        <p:spPr>
          <a:xfrm>
            <a:off x="3481435" y="337664"/>
            <a:ext cx="34145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upregulated transcripts based on Molecular function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8E0E0F5-3993-4BC6-D83A-E78A3942CB64}"/>
              </a:ext>
            </a:extLst>
          </p:cNvPr>
          <p:cNvSpPr txBox="1"/>
          <p:nvPr/>
        </p:nvSpPr>
        <p:spPr>
          <a:xfrm>
            <a:off x="0" y="2461405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6AD087F-2ECC-C712-84E3-DBA1DCFCCFE4}"/>
              </a:ext>
            </a:extLst>
          </p:cNvPr>
          <p:cNvSpPr txBox="1"/>
          <p:nvPr/>
        </p:nvSpPr>
        <p:spPr>
          <a:xfrm>
            <a:off x="2156239" y="2459025"/>
            <a:ext cx="21742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treated vs  NaClO4 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12DCF97-CF01-92C1-D551-5FE8E01F1D37}"/>
              </a:ext>
            </a:extLst>
          </p:cNvPr>
          <p:cNvSpPr txBox="1"/>
          <p:nvPr/>
        </p:nvSpPr>
        <p:spPr>
          <a:xfrm>
            <a:off x="-42087" y="2733643"/>
            <a:ext cx="3527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downregulated transcripts based on Biological processes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0713C69-ABEF-B54E-8277-5E17D4130508}"/>
              </a:ext>
            </a:extLst>
          </p:cNvPr>
          <p:cNvSpPr txBox="1"/>
          <p:nvPr/>
        </p:nvSpPr>
        <p:spPr>
          <a:xfrm>
            <a:off x="3375881" y="2738125"/>
            <a:ext cx="3527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downregulated transcripts based on Molecular function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F583A43-A77E-BE86-DADA-993DD2009264}"/>
              </a:ext>
            </a:extLst>
          </p:cNvPr>
          <p:cNvSpPr txBox="1"/>
          <p:nvPr/>
        </p:nvSpPr>
        <p:spPr>
          <a:xfrm>
            <a:off x="24989" y="4975531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655D3AD-B484-F1B7-827F-860F4FA3CA7E}"/>
              </a:ext>
            </a:extLst>
          </p:cNvPr>
          <p:cNvSpPr txBox="1"/>
          <p:nvPr/>
        </p:nvSpPr>
        <p:spPr>
          <a:xfrm>
            <a:off x="1876720" y="4975531"/>
            <a:ext cx="2598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vs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 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ClO4 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4DD9E85-2DC1-C4CA-F12B-DA6C88C97480}"/>
              </a:ext>
            </a:extLst>
          </p:cNvPr>
          <p:cNvSpPr txBox="1"/>
          <p:nvPr/>
        </p:nvSpPr>
        <p:spPr>
          <a:xfrm>
            <a:off x="-127116" y="5252398"/>
            <a:ext cx="3527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upregulated transcripts based on Biological processes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D5639D2-8DC0-F431-F58E-4852FC1702C3}"/>
              </a:ext>
            </a:extLst>
          </p:cNvPr>
          <p:cNvSpPr txBox="1"/>
          <p:nvPr/>
        </p:nvSpPr>
        <p:spPr>
          <a:xfrm>
            <a:off x="3455677" y="5252398"/>
            <a:ext cx="34145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upregulated transcripts based on Molecular function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066F1A-FEBF-A126-6A8B-19B9D5F49B52}"/>
              </a:ext>
            </a:extLst>
          </p:cNvPr>
          <p:cNvSpPr txBox="1"/>
          <p:nvPr/>
        </p:nvSpPr>
        <p:spPr>
          <a:xfrm>
            <a:off x="6586" y="7466386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45C11D3-FA4E-AADA-29B4-F7880E79C87D}"/>
              </a:ext>
            </a:extLst>
          </p:cNvPr>
          <p:cNvSpPr txBox="1"/>
          <p:nvPr/>
        </p:nvSpPr>
        <p:spPr>
          <a:xfrm>
            <a:off x="1858317" y="7466386"/>
            <a:ext cx="2598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vs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sm4</a:t>
            </a:r>
            <a:r>
              <a:rPr lang="en-US" sz="1000" b="1" i="1" dirty="0">
                <a:latin typeface="Calibri Light" panose="020F0302020204030204" pitchFamily="34" charset="0"/>
                <a:cs typeface="Calibri Light" panose="020F0302020204030204" pitchFamily="34" charset="0"/>
              </a:rPr>
              <a:t>∆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NaClO4 treat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751DF4F-A251-DF6C-F62A-D667AA2E7B0A}"/>
              </a:ext>
            </a:extLst>
          </p:cNvPr>
          <p:cNvSpPr txBox="1"/>
          <p:nvPr/>
        </p:nvSpPr>
        <p:spPr>
          <a:xfrm>
            <a:off x="-91366" y="7713113"/>
            <a:ext cx="3527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downregulated transcripts based on Biological processes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C503BE2-0E5C-B5D7-766E-05594BF94A69}"/>
              </a:ext>
            </a:extLst>
          </p:cNvPr>
          <p:cNvSpPr txBox="1"/>
          <p:nvPr/>
        </p:nvSpPr>
        <p:spPr>
          <a:xfrm>
            <a:off x="3326602" y="7717595"/>
            <a:ext cx="3527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downregulated transcripts based on Molecular function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29674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73ED3CA-033F-8ACB-1931-EDAA658DCF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79" y="468260"/>
            <a:ext cx="3357639" cy="16687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35A916E5-CDB9-F56B-7F4C-BD1F0A4CF5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26218" y="468260"/>
            <a:ext cx="3363202" cy="166466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62DFC4C-0398-1EB2-CBFF-3EF24242EB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8579" y="2794426"/>
            <a:ext cx="3357639" cy="166422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B58A117-DFBB-B25C-C1C5-1878AD63092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447443" y="2792147"/>
            <a:ext cx="3326314" cy="166878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9FC66F0-562C-CE0D-9AEA-2D28A8185B4E}"/>
              </a:ext>
            </a:extLst>
          </p:cNvPr>
          <p:cNvSpPr txBox="1"/>
          <p:nvPr/>
        </p:nvSpPr>
        <p:spPr>
          <a:xfrm>
            <a:off x="0" y="266020"/>
            <a:ext cx="3527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upregulated transcripts based on Biological processes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BF162AA-33D2-C4E1-38CC-41775D3B8068}"/>
              </a:ext>
            </a:extLst>
          </p:cNvPr>
          <p:cNvSpPr txBox="1"/>
          <p:nvPr/>
        </p:nvSpPr>
        <p:spPr>
          <a:xfrm>
            <a:off x="3417968" y="270502"/>
            <a:ext cx="3527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upregulated transcripts based on Molecular function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8770F91B-9D99-8E0F-D3DA-B9EEE829DB90}"/>
              </a:ext>
            </a:extLst>
          </p:cNvPr>
          <p:cNvCxnSpPr>
            <a:cxnSpLocks/>
          </p:cNvCxnSpPr>
          <p:nvPr/>
        </p:nvCxnSpPr>
        <p:spPr>
          <a:xfrm flipV="1">
            <a:off x="68579" y="234488"/>
            <a:ext cx="6666820" cy="75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0442E3B-4052-388B-B4C2-8A4C845B559D}"/>
              </a:ext>
            </a:extLst>
          </p:cNvPr>
          <p:cNvSpPr txBox="1"/>
          <p:nvPr/>
        </p:nvSpPr>
        <p:spPr>
          <a:xfrm>
            <a:off x="38324" y="5248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684382A-49BF-64E3-5583-C71B252CBA6B}"/>
              </a:ext>
            </a:extLst>
          </p:cNvPr>
          <p:cNvSpPr txBox="1"/>
          <p:nvPr/>
        </p:nvSpPr>
        <p:spPr>
          <a:xfrm>
            <a:off x="1890055" y="5248"/>
            <a:ext cx="2598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shocked vs shock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CCB43E2-F224-6C6A-2FE9-47FE1B08378C}"/>
              </a:ext>
            </a:extLst>
          </p:cNvPr>
          <p:cNvSpPr txBox="1"/>
          <p:nvPr/>
        </p:nvSpPr>
        <p:spPr>
          <a:xfrm>
            <a:off x="38324" y="2575904"/>
            <a:ext cx="3527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downregulated transcripts based on Biological processes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0422830-663F-E47B-BDF3-0F1D710BF4E4}"/>
              </a:ext>
            </a:extLst>
          </p:cNvPr>
          <p:cNvSpPr txBox="1"/>
          <p:nvPr/>
        </p:nvSpPr>
        <p:spPr>
          <a:xfrm>
            <a:off x="3425812" y="2580386"/>
            <a:ext cx="3527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enrichment for downregulated transcripts based on Molecular function  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275CC94-5607-5C9A-16F9-5200BA79E43D}"/>
              </a:ext>
            </a:extLst>
          </p:cNvPr>
          <p:cNvCxnSpPr>
            <a:cxnSpLocks/>
          </p:cNvCxnSpPr>
          <p:nvPr/>
        </p:nvCxnSpPr>
        <p:spPr>
          <a:xfrm flipV="1">
            <a:off x="106903" y="2544372"/>
            <a:ext cx="6666820" cy="754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5E6ED6B5-AFBD-980F-1E21-E0B32A00442A}"/>
              </a:ext>
            </a:extLst>
          </p:cNvPr>
          <p:cNvSpPr txBox="1"/>
          <p:nvPr/>
        </p:nvSpPr>
        <p:spPr>
          <a:xfrm>
            <a:off x="76648" y="2315132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03E9031-8FB5-702E-2717-84778C7477B7}"/>
              </a:ext>
            </a:extLst>
          </p:cNvPr>
          <p:cNvSpPr txBox="1"/>
          <p:nvPr/>
        </p:nvSpPr>
        <p:spPr>
          <a:xfrm>
            <a:off x="1928379" y="2315132"/>
            <a:ext cx="2598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shocked vs shock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 Box 2">
            <a:extLst>
              <a:ext uri="{FF2B5EF4-FFF2-40B4-BE49-F238E27FC236}">
                <a16:creationId xmlns:a16="http://schemas.microsoft.com/office/drawing/2014/main" id="{A273BA2B-A53C-A5ED-33C0-AEEC328A51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8029" y="4505261"/>
            <a:ext cx="6499878" cy="1710652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/>
            <a:r>
              <a:rPr lang="en-US" sz="1000" b="1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5</a:t>
            </a:r>
            <a:r>
              <a:rPr lang="en-US" sz="10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: Gene Ontology enrichment analysis for differentially expressed genes. 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GO enrichment analysis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for upregulated transcripts based on biological processes and molecular function in [A] wildtype untreated vs sodium perchlorate treated cells, [C] wildtype vs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∆lsm4∆C</a:t>
            </a:r>
            <a:r>
              <a:rPr lang="en-US" sz="1000" i="1" dirty="0"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sodium perchlorate treated cells, [E] wildtype unshocked vs 5.6M shocked cells.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GO enrichment analysis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for downregulated transcripts based on biological processes and molecular function in- [B] wildtype untreated vs sodium perchlorate treated cells, [D] wildtype vs </a:t>
            </a:r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c3∆lsm4∆C</a:t>
            </a:r>
            <a:r>
              <a:rPr lang="en-US" sz="1000" i="1" dirty="0"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sodium perchlorate treated cells, [F] wildtype unshocked vs 5.6M shocked cells. </a:t>
            </a:r>
            <a:endParaRPr lang="en-IN" sz="10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7078776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25EFDBCB-22C9-A0AD-BD57-C04BBA1C7FC5}"/>
              </a:ext>
            </a:extLst>
          </p:cNvPr>
          <p:cNvGrpSpPr/>
          <p:nvPr/>
        </p:nvGrpSpPr>
        <p:grpSpPr>
          <a:xfrm>
            <a:off x="0" y="2378509"/>
            <a:ext cx="3545787" cy="2781300"/>
            <a:chOff x="160358" y="144780"/>
            <a:chExt cx="3545787" cy="27813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FBCE2CE-AA8F-4A11-B79F-D43A6849E0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t="8307"/>
            <a:stretch/>
          </p:blipFill>
          <p:spPr>
            <a:xfrm>
              <a:off x="160358" y="144780"/>
              <a:ext cx="3545787" cy="27813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E59A92B-382D-B570-F318-96276407BD5E}"/>
                </a:ext>
              </a:extLst>
            </p:cNvPr>
            <p:cNvSpPr txBox="1"/>
            <p:nvPr/>
          </p:nvSpPr>
          <p:spPr>
            <a:xfrm>
              <a:off x="2208715" y="327660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10</a:t>
              </a:r>
              <a:endParaRPr lang="en-IN" sz="6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80C0BE1-57E4-56A5-0567-6F8F3752520F}"/>
                </a:ext>
              </a:extLst>
            </p:cNvPr>
            <p:cNvSpPr txBox="1"/>
            <p:nvPr/>
          </p:nvSpPr>
          <p:spPr>
            <a:xfrm>
              <a:off x="2146670" y="602873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bg1"/>
                  </a:solidFill>
                </a:rPr>
                <a:t>33</a:t>
              </a:r>
              <a:endParaRPr lang="en-IN" sz="600" b="1" dirty="0">
                <a:solidFill>
                  <a:schemeClr val="bg1"/>
                </a:solidFill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FB32751-078D-5098-EA19-57543A3C77AF}"/>
                </a:ext>
              </a:extLst>
            </p:cNvPr>
            <p:cNvSpPr txBox="1"/>
            <p:nvPr/>
          </p:nvSpPr>
          <p:spPr>
            <a:xfrm>
              <a:off x="2100950" y="863370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38</a:t>
              </a:r>
              <a:endParaRPr lang="en-IN" sz="600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579BF23-03ED-22BB-98BA-8606535031DE}"/>
                </a:ext>
              </a:extLst>
            </p:cNvPr>
            <p:cNvSpPr txBox="1"/>
            <p:nvPr/>
          </p:nvSpPr>
          <p:spPr>
            <a:xfrm>
              <a:off x="2251180" y="1131487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20</a:t>
              </a:r>
              <a:endParaRPr lang="en-IN" sz="600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C0148E4-A0F0-1193-533E-29FE433D85BC}"/>
                </a:ext>
              </a:extLst>
            </p:cNvPr>
            <p:cNvSpPr txBox="1"/>
            <p:nvPr/>
          </p:nvSpPr>
          <p:spPr>
            <a:xfrm>
              <a:off x="2698739" y="1404104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bg1"/>
                  </a:solidFill>
                </a:rPr>
                <a:t>43</a:t>
              </a:r>
              <a:endParaRPr lang="en-IN" sz="600" b="1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BF95643-31CD-C317-2FC9-556665AF9401}"/>
                </a:ext>
              </a:extLst>
            </p:cNvPr>
            <p:cNvSpPr txBox="1"/>
            <p:nvPr/>
          </p:nvSpPr>
          <p:spPr>
            <a:xfrm>
              <a:off x="2785778" y="1684052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bg1"/>
                  </a:solidFill>
                </a:rPr>
                <a:t>55</a:t>
              </a:r>
              <a:endParaRPr lang="en-IN" sz="600" b="1" dirty="0">
                <a:solidFill>
                  <a:schemeClr val="bg1"/>
                </a:solidFill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7CBCA3C-77A7-4A4F-C640-511928FA1AC6}"/>
                </a:ext>
              </a:extLst>
            </p:cNvPr>
            <p:cNvSpPr txBox="1"/>
            <p:nvPr/>
          </p:nvSpPr>
          <p:spPr>
            <a:xfrm>
              <a:off x="2698739" y="1964000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bg1"/>
                  </a:solidFill>
                </a:rPr>
                <a:t>46</a:t>
              </a:r>
              <a:endParaRPr lang="en-IN" sz="600" b="1" dirty="0">
                <a:solidFill>
                  <a:schemeClr val="bg1"/>
                </a:solidFill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A6C8EB7-C969-EA80-9D98-86A0F524805C}"/>
                </a:ext>
              </a:extLst>
            </p:cNvPr>
            <p:cNvSpPr txBox="1"/>
            <p:nvPr/>
          </p:nvSpPr>
          <p:spPr>
            <a:xfrm>
              <a:off x="3080937" y="2220353"/>
              <a:ext cx="2590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chemeClr val="bg1"/>
                  </a:solidFill>
                </a:rPr>
                <a:t>87</a:t>
              </a:r>
              <a:endParaRPr lang="en-IN" sz="600" b="1" dirty="0">
                <a:solidFill>
                  <a:schemeClr val="bg1"/>
                </a:solidFill>
              </a:endParaRPr>
            </a:p>
          </p:txBody>
        </p:sp>
      </p:grpSp>
      <p:pic>
        <p:nvPicPr>
          <p:cNvPr id="18" name="Picture 17">
            <a:extLst>
              <a:ext uri="{FF2B5EF4-FFF2-40B4-BE49-F238E27FC236}">
                <a16:creationId xmlns:a16="http://schemas.microsoft.com/office/drawing/2014/main" id="{7E47F3AA-43C6-3487-6B49-2BA29440BDD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09287" y="2422144"/>
            <a:ext cx="1895134" cy="1642489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1826DCF-0E23-21D9-2DD6-6979BD97FD8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333" r="14445"/>
          <a:stretch/>
        </p:blipFill>
        <p:spPr>
          <a:xfrm>
            <a:off x="4868868" y="2214943"/>
            <a:ext cx="1757193" cy="2075119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EEA2E2DA-C77E-5828-4854-572195AA478A}"/>
              </a:ext>
            </a:extLst>
          </p:cNvPr>
          <p:cNvSpPr txBox="1"/>
          <p:nvPr/>
        </p:nvSpPr>
        <p:spPr>
          <a:xfrm>
            <a:off x="3804967" y="4294386"/>
            <a:ext cx="9972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ylation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72CF2CC-0DF1-6376-13BC-1199959E0432}"/>
              </a:ext>
            </a:extLst>
          </p:cNvPr>
          <p:cNvSpPr txBox="1"/>
          <p:nvPr/>
        </p:nvSpPr>
        <p:spPr>
          <a:xfrm>
            <a:off x="5274666" y="4297756"/>
            <a:ext cx="13081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respiration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11BC5881-1357-333A-9158-A663037BE93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8809" t="26912" b="1072"/>
          <a:stretch/>
        </p:blipFill>
        <p:spPr>
          <a:xfrm>
            <a:off x="3563289" y="5397556"/>
            <a:ext cx="2022269" cy="2367193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46BDEB89-AAA4-516D-42D7-46F3687B6145}"/>
              </a:ext>
            </a:extLst>
          </p:cNvPr>
          <p:cNvSpPr txBox="1"/>
          <p:nvPr/>
        </p:nvSpPr>
        <p:spPr>
          <a:xfrm>
            <a:off x="4363324" y="7498473"/>
            <a:ext cx="9113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shocked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ABE67C1D-07A9-DD1D-D29A-5F389177FC5E}"/>
              </a:ext>
            </a:extLst>
          </p:cNvPr>
          <p:cNvCxnSpPr>
            <a:cxnSpLocks/>
          </p:cNvCxnSpPr>
          <p:nvPr/>
        </p:nvCxnSpPr>
        <p:spPr>
          <a:xfrm>
            <a:off x="4116346" y="7504115"/>
            <a:ext cx="13144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98AAD4A8-B4AF-4B66-47FE-8A0413857CFD}"/>
              </a:ext>
            </a:extLst>
          </p:cNvPr>
          <p:cNvCxnSpPr>
            <a:cxnSpLocks/>
          </p:cNvCxnSpPr>
          <p:nvPr/>
        </p:nvCxnSpPr>
        <p:spPr>
          <a:xfrm>
            <a:off x="4003763" y="5897030"/>
            <a:ext cx="2577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6B461AFC-A564-538E-C7AF-C0BE8C5BCC65}"/>
              </a:ext>
            </a:extLst>
          </p:cNvPr>
          <p:cNvCxnSpPr>
            <a:cxnSpLocks/>
          </p:cNvCxnSpPr>
          <p:nvPr/>
        </p:nvCxnSpPr>
        <p:spPr>
          <a:xfrm>
            <a:off x="4005859" y="5811305"/>
            <a:ext cx="50567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53EC9FA8-D923-E43A-9E09-AEFA86BFE04E}"/>
              </a:ext>
            </a:extLst>
          </p:cNvPr>
          <p:cNvCxnSpPr>
            <a:cxnSpLocks/>
          </p:cNvCxnSpPr>
          <p:nvPr/>
        </p:nvCxnSpPr>
        <p:spPr>
          <a:xfrm>
            <a:off x="4003763" y="5725580"/>
            <a:ext cx="7698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FA5051A9-3835-8155-C954-696E6B89D03E}"/>
              </a:ext>
            </a:extLst>
          </p:cNvPr>
          <p:cNvCxnSpPr>
            <a:cxnSpLocks/>
          </p:cNvCxnSpPr>
          <p:nvPr/>
        </p:nvCxnSpPr>
        <p:spPr>
          <a:xfrm>
            <a:off x="4003763" y="5642236"/>
            <a:ext cx="10197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2007878E-1B97-E077-618A-5728379FA077}"/>
              </a:ext>
            </a:extLst>
          </p:cNvPr>
          <p:cNvCxnSpPr>
            <a:cxnSpLocks/>
          </p:cNvCxnSpPr>
          <p:nvPr/>
        </p:nvCxnSpPr>
        <p:spPr>
          <a:xfrm flipV="1">
            <a:off x="4003859" y="5554131"/>
            <a:ext cx="1293491" cy="476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6" name="Group 15">
            <a:extLst>
              <a:ext uri="{FF2B5EF4-FFF2-40B4-BE49-F238E27FC236}">
                <a16:creationId xmlns:a16="http://schemas.microsoft.com/office/drawing/2014/main" id="{51D6AAA3-DDBE-5BA1-EE73-35299A5FCCA5}"/>
              </a:ext>
            </a:extLst>
          </p:cNvPr>
          <p:cNvGrpSpPr/>
          <p:nvPr/>
        </p:nvGrpSpPr>
        <p:grpSpPr>
          <a:xfrm>
            <a:off x="910194" y="5397556"/>
            <a:ext cx="2132416" cy="2367193"/>
            <a:chOff x="1289255" y="3325041"/>
            <a:chExt cx="2132416" cy="2367193"/>
          </a:xfrm>
        </p:grpSpPr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132F1A6C-87FE-3DF9-FDDD-0B6C24AE3F1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31172"/>
            <a:stretch/>
          </p:blipFill>
          <p:spPr>
            <a:xfrm>
              <a:off x="1289255" y="3325041"/>
              <a:ext cx="2132416" cy="2367193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AC221445-FE18-3E8B-2C3F-F4524368CFA8}"/>
                </a:ext>
              </a:extLst>
            </p:cNvPr>
            <p:cNvSpPr txBox="1"/>
            <p:nvPr/>
          </p:nvSpPr>
          <p:spPr>
            <a:xfrm>
              <a:off x="2192943" y="5402973"/>
              <a:ext cx="9113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 shocked</a:t>
              </a:r>
              <a:endParaRPr lang="en-IN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31619973-4B8B-7499-9962-3C8F56E61845}"/>
                </a:ext>
              </a:extLst>
            </p:cNvPr>
            <p:cNvCxnSpPr>
              <a:cxnSpLocks/>
            </p:cNvCxnSpPr>
            <p:nvPr/>
          </p:nvCxnSpPr>
          <p:spPr>
            <a:xfrm>
              <a:off x="1945965" y="5408615"/>
              <a:ext cx="131445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0E3DDFAF-EE6E-F74B-37BF-2C010D39AE55}"/>
                </a:ext>
              </a:extLst>
            </p:cNvPr>
            <p:cNvCxnSpPr>
              <a:cxnSpLocks/>
            </p:cNvCxnSpPr>
            <p:nvPr/>
          </p:nvCxnSpPr>
          <p:spPr>
            <a:xfrm>
              <a:off x="1899395" y="4151980"/>
              <a:ext cx="31130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283F5E3A-31B5-26BB-9769-D3D8E00A3BC0}"/>
                </a:ext>
              </a:extLst>
            </p:cNvPr>
            <p:cNvCxnSpPr>
              <a:cxnSpLocks/>
            </p:cNvCxnSpPr>
            <p:nvPr/>
          </p:nvCxnSpPr>
          <p:spPr>
            <a:xfrm>
              <a:off x="1899395" y="4025773"/>
              <a:ext cx="616655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27091E83-A3BF-6E49-13D7-9EA7A055F244}"/>
                </a:ext>
              </a:extLst>
            </p:cNvPr>
            <p:cNvCxnSpPr>
              <a:cxnSpLocks/>
            </p:cNvCxnSpPr>
            <p:nvPr/>
          </p:nvCxnSpPr>
          <p:spPr>
            <a:xfrm>
              <a:off x="1899395" y="3932904"/>
              <a:ext cx="91431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8E4F5B9F-3E2F-6C4E-E863-7A67CE7D1970}"/>
                </a:ext>
              </a:extLst>
            </p:cNvPr>
            <p:cNvCxnSpPr>
              <a:cxnSpLocks/>
            </p:cNvCxnSpPr>
            <p:nvPr/>
          </p:nvCxnSpPr>
          <p:spPr>
            <a:xfrm>
              <a:off x="1898307" y="3749548"/>
              <a:ext cx="123210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C5832A1D-FC69-B8BA-A077-0999064B4E3C}"/>
                </a:ext>
              </a:extLst>
            </p:cNvPr>
            <p:cNvSpPr txBox="1"/>
            <p:nvPr/>
          </p:nvSpPr>
          <p:spPr>
            <a:xfrm>
              <a:off x="1888466" y="4001984"/>
              <a:ext cx="311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en-I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E8FC115F-70A1-21E7-964A-8031C57BBDED}"/>
                </a:ext>
              </a:extLst>
            </p:cNvPr>
            <p:cNvSpPr txBox="1"/>
            <p:nvPr/>
          </p:nvSpPr>
          <p:spPr>
            <a:xfrm>
              <a:off x="2006123" y="3875755"/>
              <a:ext cx="311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en-I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C5EE1A04-A46A-908A-F72C-DF9F8A8E4B4A}"/>
                </a:ext>
              </a:extLst>
            </p:cNvPr>
            <p:cNvSpPr txBox="1"/>
            <p:nvPr/>
          </p:nvSpPr>
          <p:spPr>
            <a:xfrm>
              <a:off x="2270619" y="3592694"/>
              <a:ext cx="311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I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id="{39B39B7D-41EC-8FDE-C36F-0B19DB0D562C}"/>
                </a:ext>
              </a:extLst>
            </p:cNvPr>
            <p:cNvSpPr txBox="1"/>
            <p:nvPr/>
          </p:nvSpPr>
          <p:spPr>
            <a:xfrm>
              <a:off x="2254261" y="3776456"/>
              <a:ext cx="311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IN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3" name="TextBox 172">
            <a:extLst>
              <a:ext uri="{FF2B5EF4-FFF2-40B4-BE49-F238E27FC236}">
                <a16:creationId xmlns:a16="http://schemas.microsoft.com/office/drawing/2014/main" id="{124B5635-5E9E-C22B-7A6F-E57A4D916D20}"/>
              </a:ext>
            </a:extLst>
          </p:cNvPr>
          <p:cNvSpPr txBox="1"/>
          <p:nvPr/>
        </p:nvSpPr>
        <p:spPr>
          <a:xfrm>
            <a:off x="4008905" y="5748845"/>
            <a:ext cx="311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43A20146-F190-ED56-30FD-AF50747D9B77}"/>
              </a:ext>
            </a:extLst>
          </p:cNvPr>
          <p:cNvSpPr txBox="1"/>
          <p:nvPr/>
        </p:nvSpPr>
        <p:spPr>
          <a:xfrm>
            <a:off x="4160861" y="5665501"/>
            <a:ext cx="311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A2B9A0CE-D4C6-534E-4DBF-EC9EF753ADED}"/>
              </a:ext>
            </a:extLst>
          </p:cNvPr>
          <p:cNvSpPr txBox="1"/>
          <p:nvPr/>
        </p:nvSpPr>
        <p:spPr>
          <a:xfrm>
            <a:off x="4253159" y="5582156"/>
            <a:ext cx="311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7E2329FC-CE55-7CCD-F079-6EC0F2D116A7}"/>
              </a:ext>
            </a:extLst>
          </p:cNvPr>
          <p:cNvSpPr txBox="1"/>
          <p:nvPr/>
        </p:nvSpPr>
        <p:spPr>
          <a:xfrm>
            <a:off x="4412509" y="5505942"/>
            <a:ext cx="311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IN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02E541E1-5BBE-D579-06CB-733891AC17E5}"/>
              </a:ext>
            </a:extLst>
          </p:cNvPr>
          <p:cNvSpPr txBox="1"/>
          <p:nvPr/>
        </p:nvSpPr>
        <p:spPr>
          <a:xfrm>
            <a:off x="4640013" y="5389562"/>
            <a:ext cx="311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en-I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4E1837D-6E22-D805-A3C4-39C030AC07DC}"/>
              </a:ext>
            </a:extLst>
          </p:cNvPr>
          <p:cNvSpPr txBox="1"/>
          <p:nvPr/>
        </p:nvSpPr>
        <p:spPr>
          <a:xfrm rot="16200000">
            <a:off x="2850400" y="6297494"/>
            <a:ext cx="13998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RNA abundance</a:t>
            </a:r>
            <a:endParaRPr lang="en-IN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E6F1D5A-D311-77E7-80ED-47799DA6F56C}"/>
              </a:ext>
            </a:extLst>
          </p:cNvPr>
          <p:cNvSpPr txBox="1"/>
          <p:nvPr/>
        </p:nvSpPr>
        <p:spPr>
          <a:xfrm>
            <a:off x="0" y="133676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DD19DAC-88C2-09E4-54B4-C491F9A376B8}"/>
              </a:ext>
            </a:extLst>
          </p:cNvPr>
          <p:cNvSpPr txBox="1"/>
          <p:nvPr/>
        </p:nvSpPr>
        <p:spPr>
          <a:xfrm>
            <a:off x="0" y="2117878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CA20D5C-E918-1AFF-CF23-E5812A807D08}"/>
              </a:ext>
            </a:extLst>
          </p:cNvPr>
          <p:cNvSpPr txBox="1"/>
          <p:nvPr/>
        </p:nvSpPr>
        <p:spPr>
          <a:xfrm>
            <a:off x="4544227" y="2171926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3AC4B4B-22F2-650C-B2A5-6188A6947277}"/>
              </a:ext>
            </a:extLst>
          </p:cNvPr>
          <p:cNvSpPr txBox="1"/>
          <p:nvPr/>
        </p:nvSpPr>
        <p:spPr>
          <a:xfrm>
            <a:off x="711394" y="5129309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0D8264D-8753-D3F3-8D01-F7E9FED276D1}"/>
              </a:ext>
            </a:extLst>
          </p:cNvPr>
          <p:cNvSpPr txBox="1"/>
          <p:nvPr/>
        </p:nvSpPr>
        <p:spPr>
          <a:xfrm>
            <a:off x="3148187" y="5129309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F21B6E2-2AA0-327C-62BD-42EAE00A16AA}"/>
              </a:ext>
            </a:extLst>
          </p:cNvPr>
          <p:cNvSpPr txBox="1"/>
          <p:nvPr/>
        </p:nvSpPr>
        <p:spPr>
          <a:xfrm>
            <a:off x="1114222" y="2162074"/>
            <a:ext cx="1487260" cy="1876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1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shocked vs  shocked</a:t>
            </a:r>
            <a:endParaRPr lang="en-IN" sz="6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FDA1F9E-D9FD-28DB-BC76-88789C96A0D9}"/>
              </a:ext>
            </a:extLst>
          </p:cNvPr>
          <p:cNvSpPr txBox="1"/>
          <p:nvPr/>
        </p:nvSpPr>
        <p:spPr>
          <a:xfrm>
            <a:off x="198800" y="7768852"/>
            <a:ext cx="6582777" cy="20928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i="1" kern="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Supplementary Figure 6: Transcriptomic analysis in wildtype reveals differential gene expression during recovery from shock waves. </a:t>
            </a:r>
            <a:r>
              <a:rPr lang="en-US" sz="1000" kern="0" dirty="0">
                <a:latin typeface="Times New Roman" panose="02020603050405020304" pitchFamily="18" charset="0"/>
                <a:ea typeface="SimSun" panose="02010600030101010101" pitchFamily="2" charset="-122"/>
              </a:rPr>
              <a:t>[A]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</a:rPr>
              <a:t> Volcano plot showing changes in transcripts level in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 cells post exposure to 5.6 M intensity shock waves. </a:t>
            </a:r>
            <a:r>
              <a:rPr lang="en-IN" sz="10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0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dots represent up-regulated transcripts having log2fc &gt;0.05, the red dots represent down-regulated transcripts having log2fc &lt;0.05, and neutrally expressed transcripts are represented as black.</a:t>
            </a:r>
            <a:r>
              <a:rPr lang="en-US" sz="1000" b="1" kern="0" dirty="0">
                <a:latin typeface="Times New Roman" panose="02020603050405020304" pitchFamily="18" charset="0"/>
                <a:ea typeface="SimSun" panose="02010600030101010101" pitchFamily="2" charset="-122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B] Gene enrichment analysis based on the biological process of differentially expressed genes in wild-type cells post exposure to 5.6 M intensity shock waves. The X-axis represents the number of genes; a positive x-axis refers to upregulated transcripts, and a negative x-axis represents downregulated transcripts. [C] String analysis for a upregulated biological process enriched in wildtype cells post exposure to 5.6 M intensity shock waves.</a:t>
            </a:r>
            <a:r>
              <a:rPr lang="en-US" sz="10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D] String analysis for a downregulated biological process enriched in wildtype cells post exposure to 5.6 M intensity shock waves.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 [E] Validation of upregulated genes by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qRT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-PCR in wildtype unshocked vs shocked condition. [F] Validation of downregulated genes by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qRT</a:t>
            </a:r>
            <a:r>
              <a:rPr lang="en-US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-PCR in wildtype unshocked vs shocked condition. For all validations PGK1 was used as internal control. 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 the above experiments, error bars represent Standard Error of the Mean. </a:t>
            </a:r>
            <a:r>
              <a:rPr lang="en-IN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significance of the data was calculated by paired </a:t>
            </a:r>
            <a:r>
              <a:rPr lang="en-IN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</a:t>
            </a:r>
            <a:r>
              <a:rPr lang="en-IN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-test and </a:t>
            </a:r>
            <a:r>
              <a:rPr lang="en-IN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-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values are summarized as: </a:t>
            </a:r>
            <a:r>
              <a:rPr lang="en-US" sz="1000" kern="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**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 &lt;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0.005; </a:t>
            </a:r>
            <a:r>
              <a:rPr lang="en-US" sz="1000" kern="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*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 &lt;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0.01; </a:t>
            </a:r>
            <a:r>
              <a:rPr lang="en-US" sz="1000" kern="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en-US" sz="100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 &lt;</a:t>
            </a:r>
            <a:r>
              <a:rPr lang="en-US" sz="10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0.05 *.</a:t>
            </a:r>
            <a:endParaRPr lang="en-IN" sz="1000" dirty="0"/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016A4B11-5CDC-9A6E-5205-197C03ABFF1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5100" y="357530"/>
            <a:ext cx="1954802" cy="1767704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D87161C9-4522-5239-15A1-9D1603BCD444}"/>
              </a:ext>
            </a:extLst>
          </p:cNvPr>
          <p:cNvSpPr txBox="1"/>
          <p:nvPr/>
        </p:nvSpPr>
        <p:spPr>
          <a:xfrm>
            <a:off x="474240" y="104856"/>
            <a:ext cx="23056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unshocked vs WT shocked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18BDEDD-9EEC-8E16-DD48-D0A4E6CEF1EE}"/>
              </a:ext>
            </a:extLst>
          </p:cNvPr>
          <p:cNvSpPr txBox="1"/>
          <p:nvPr/>
        </p:nvSpPr>
        <p:spPr>
          <a:xfrm>
            <a:off x="2782059" y="2117878"/>
            <a:ext cx="397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n-IN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1124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3434</TotalTime>
  <Words>1691</Words>
  <Application>Microsoft Office PowerPoint</Application>
  <PresentationFormat>A4 Paper (210x297 mm)</PresentationFormat>
  <Paragraphs>152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ya Dhage</dc:creator>
  <cp:lastModifiedBy>Riya Dhage</cp:lastModifiedBy>
  <cp:revision>40</cp:revision>
  <cp:lastPrinted>2025-07-06T03:42:16Z</cp:lastPrinted>
  <dcterms:created xsi:type="dcterms:W3CDTF">2025-03-05T14:05:22Z</dcterms:created>
  <dcterms:modified xsi:type="dcterms:W3CDTF">2025-07-09T16:10:11Z</dcterms:modified>
</cp:coreProperties>
</file>